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1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2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3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4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5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3" r:id="rId2"/>
    <p:sldId id="260" r:id="rId3"/>
    <p:sldId id="258" r:id="rId4"/>
    <p:sldId id="259" r:id="rId5"/>
    <p:sldId id="262" r:id="rId6"/>
    <p:sldId id="261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A729F21-364D-4F8F-87D4-42DDD6AE3364}" v="97" dt="2021-05-06T12:05:54.31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2567" autoAdjust="0"/>
  </p:normalViewPr>
  <p:slideViewPr>
    <p:cSldViewPr snapToGrid="0">
      <p:cViewPr varScale="1">
        <p:scale>
          <a:sx n="154" d="100"/>
          <a:sy n="154" d="100"/>
        </p:scale>
        <p:origin x="496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이선영" userId="91632b05-5949-44db-840d-a7fdc9de9d00" providerId="ADAL" clId="{EA729F21-364D-4F8F-87D4-42DDD6AE3364}"/>
    <pc:docChg chg="undo custSel addSld delSld modSld">
      <pc:chgData name="이선영" userId="91632b05-5949-44db-840d-a7fdc9de9d00" providerId="ADAL" clId="{EA729F21-364D-4F8F-87D4-42DDD6AE3364}" dt="2021-05-06T12:07:19.492" v="832" actId="6549"/>
      <pc:docMkLst>
        <pc:docMk/>
      </pc:docMkLst>
      <pc:sldChg chg="delSp del mod">
        <pc:chgData name="이선영" userId="91632b05-5949-44db-840d-a7fdc9de9d00" providerId="ADAL" clId="{EA729F21-364D-4F8F-87D4-42DDD6AE3364}" dt="2021-05-03T23:17:42.560" v="352" actId="47"/>
        <pc:sldMkLst>
          <pc:docMk/>
          <pc:sldMk cId="3850723111" sldId="256"/>
        </pc:sldMkLst>
        <pc:graphicFrameChg chg="del">
          <ac:chgData name="이선영" userId="91632b05-5949-44db-840d-a7fdc9de9d00" providerId="ADAL" clId="{EA729F21-364D-4F8F-87D4-42DDD6AE3364}" dt="2021-05-03T23:17:38.444" v="351" actId="21"/>
          <ac:graphicFrameMkLst>
            <pc:docMk/>
            <pc:sldMk cId="3850723111" sldId="256"/>
            <ac:graphicFrameMk id="4" creationId="{00000000-0000-0000-0000-000000000000}"/>
          </ac:graphicFrameMkLst>
        </pc:graphicFrameChg>
      </pc:sldChg>
      <pc:sldChg chg="addSp delSp modSp mod modNotesTx">
        <pc:chgData name="이선영" userId="91632b05-5949-44db-840d-a7fdc9de9d00" providerId="ADAL" clId="{EA729F21-364D-4F8F-87D4-42DDD6AE3364}" dt="2021-05-06T12:07:19.492" v="832" actId="6549"/>
        <pc:sldMkLst>
          <pc:docMk/>
          <pc:sldMk cId="2013896836" sldId="257"/>
        </pc:sldMkLst>
        <pc:spChg chg="add del mod">
          <ac:chgData name="이선영" userId="91632b05-5949-44db-840d-a7fdc9de9d00" providerId="ADAL" clId="{EA729F21-364D-4F8F-87D4-42DDD6AE3364}" dt="2021-05-03T23:21:26.192" v="388" actId="478"/>
          <ac:spMkLst>
            <pc:docMk/>
            <pc:sldMk cId="2013896836" sldId="257"/>
            <ac:spMk id="3" creationId="{9D90814E-DB44-41AA-AAF9-BAFC7C90030C}"/>
          </ac:spMkLst>
        </pc:spChg>
        <pc:spChg chg="del mod">
          <ac:chgData name="이선영" userId="91632b05-5949-44db-840d-a7fdc9de9d00" providerId="ADAL" clId="{EA729F21-364D-4F8F-87D4-42DDD6AE3364}" dt="2021-05-03T23:07:47.562" v="111" actId="478"/>
          <ac:spMkLst>
            <pc:docMk/>
            <pc:sldMk cId="2013896836" sldId="257"/>
            <ac:spMk id="5" creationId="{00000000-0000-0000-0000-000000000000}"/>
          </ac:spMkLst>
        </pc:spChg>
        <pc:spChg chg="del mod">
          <ac:chgData name="이선영" userId="91632b05-5949-44db-840d-a7fdc9de9d00" providerId="ADAL" clId="{EA729F21-364D-4F8F-87D4-42DDD6AE3364}" dt="2021-05-03T23:07:47.562" v="111" actId="478"/>
          <ac:spMkLst>
            <pc:docMk/>
            <pc:sldMk cId="2013896836" sldId="257"/>
            <ac:spMk id="6" creationId="{00000000-0000-0000-0000-000000000000}"/>
          </ac:spMkLst>
        </pc:spChg>
        <pc:spChg chg="add mod">
          <ac:chgData name="이선영" userId="91632b05-5949-44db-840d-a7fdc9de9d00" providerId="ADAL" clId="{EA729F21-364D-4F8F-87D4-42DDD6AE3364}" dt="2021-05-03T23:08:44.798" v="126" actId="1076"/>
          <ac:spMkLst>
            <pc:docMk/>
            <pc:sldMk cId="2013896836" sldId="257"/>
            <ac:spMk id="8" creationId="{6574E5A5-315D-4B72-9612-9B214D4AC6B3}"/>
          </ac:spMkLst>
        </pc:spChg>
        <pc:spChg chg="add mod">
          <ac:chgData name="이선영" userId="91632b05-5949-44db-840d-a7fdc9de9d00" providerId="ADAL" clId="{EA729F21-364D-4F8F-87D4-42DDD6AE3364}" dt="2021-05-03T23:08:44.798" v="126" actId="1076"/>
          <ac:spMkLst>
            <pc:docMk/>
            <pc:sldMk cId="2013896836" sldId="257"/>
            <ac:spMk id="9" creationId="{95F2DC4F-982D-4E7A-B47D-E847A3DBD802}"/>
          </ac:spMkLst>
        </pc:spChg>
        <pc:spChg chg="add mod">
          <ac:chgData name="이선영" userId="91632b05-5949-44db-840d-a7fdc9de9d00" providerId="ADAL" clId="{EA729F21-364D-4F8F-87D4-42DDD6AE3364}" dt="2021-05-06T12:05:07.029" v="801"/>
          <ac:spMkLst>
            <pc:docMk/>
            <pc:sldMk cId="2013896836" sldId="257"/>
            <ac:spMk id="10" creationId="{8ED8B0B6-3721-441A-A53B-B79949F188A2}"/>
          </ac:spMkLst>
        </pc:spChg>
        <pc:spChg chg="add mod">
          <ac:chgData name="이선영" userId="91632b05-5949-44db-840d-a7fdc9de9d00" providerId="ADAL" clId="{EA729F21-364D-4F8F-87D4-42DDD6AE3364}" dt="2021-05-06T12:04:48.313" v="778" actId="20577"/>
          <ac:spMkLst>
            <pc:docMk/>
            <pc:sldMk cId="2013896836" sldId="257"/>
            <ac:spMk id="11" creationId="{1B80EF7B-E419-4F4E-880E-D25689C9F8E7}"/>
          </ac:spMkLst>
        </pc:spChg>
        <pc:spChg chg="add del mod">
          <ac:chgData name="이선영" userId="91632b05-5949-44db-840d-a7fdc9de9d00" providerId="ADAL" clId="{EA729F21-364D-4F8F-87D4-42DDD6AE3364}" dt="2021-05-03T23:21:43.681" v="395" actId="21"/>
          <ac:spMkLst>
            <pc:docMk/>
            <pc:sldMk cId="2013896836" sldId="257"/>
            <ac:spMk id="12" creationId="{E1CA32BF-A8E6-40FD-B4E6-E92C9E07D768}"/>
          </ac:spMkLst>
        </pc:spChg>
        <pc:spChg chg="add del mod">
          <ac:chgData name="이선영" userId="91632b05-5949-44db-840d-a7fdc9de9d00" providerId="ADAL" clId="{EA729F21-364D-4F8F-87D4-42DDD6AE3364}" dt="2021-05-03T23:22:33.070" v="406" actId="21"/>
          <ac:spMkLst>
            <pc:docMk/>
            <pc:sldMk cId="2013896836" sldId="257"/>
            <ac:spMk id="13" creationId="{C9E0A3D3-AE45-41E9-9D36-2681A06AB7A1}"/>
          </ac:spMkLst>
        </pc:spChg>
        <pc:spChg chg="add mod">
          <ac:chgData name="이선영" userId="91632b05-5949-44db-840d-a7fdc9de9d00" providerId="ADAL" clId="{EA729F21-364D-4F8F-87D4-42DDD6AE3364}" dt="2021-05-03T23:29:53.416" v="480" actId="20577"/>
          <ac:spMkLst>
            <pc:docMk/>
            <pc:sldMk cId="2013896836" sldId="257"/>
            <ac:spMk id="16" creationId="{74664E0F-6262-4652-952C-C8FADA7A759F}"/>
          </ac:spMkLst>
        </pc:spChg>
        <pc:spChg chg="add mod">
          <ac:chgData name="이선영" userId="91632b05-5949-44db-840d-a7fdc9de9d00" providerId="ADAL" clId="{EA729F21-364D-4F8F-87D4-42DDD6AE3364}" dt="2021-05-03T23:30:01.385" v="483" actId="20577"/>
          <ac:spMkLst>
            <pc:docMk/>
            <pc:sldMk cId="2013896836" sldId="257"/>
            <ac:spMk id="18" creationId="{AFEDD439-12C8-41EE-A1B9-52E11E393539}"/>
          </ac:spMkLst>
        </pc:spChg>
        <pc:graphicFrameChg chg="del mod">
          <ac:chgData name="이선영" userId="91632b05-5949-44db-840d-a7fdc9de9d00" providerId="ADAL" clId="{EA729F21-364D-4F8F-87D4-42DDD6AE3364}" dt="2021-05-03T23:21:01.170" v="384" actId="478"/>
          <ac:graphicFrameMkLst>
            <pc:docMk/>
            <pc:sldMk cId="2013896836" sldId="257"/>
            <ac:graphicFrameMk id="4" creationId="{40269DEF-5F7A-49AF-9BF1-B7013EADC554}"/>
          </ac:graphicFrameMkLst>
        </pc:graphicFrameChg>
        <pc:graphicFrameChg chg="del mod">
          <ac:chgData name="이선영" userId="91632b05-5949-44db-840d-a7fdc9de9d00" providerId="ADAL" clId="{EA729F21-364D-4F8F-87D4-42DDD6AE3364}" dt="2021-05-03T23:21:01.170" v="384" actId="478"/>
          <ac:graphicFrameMkLst>
            <pc:docMk/>
            <pc:sldMk cId="2013896836" sldId="257"/>
            <ac:graphicFrameMk id="7" creationId="{1179BCFE-A831-4629-B9E4-2F220BA966CF}"/>
          </ac:graphicFrameMkLst>
        </pc:graphicFrameChg>
        <pc:graphicFrameChg chg="add del mod">
          <ac:chgData name="이선영" userId="91632b05-5949-44db-840d-a7fdc9de9d00" providerId="ADAL" clId="{EA729F21-364D-4F8F-87D4-42DDD6AE3364}" dt="2021-05-03T23:22:24.997" v="402" actId="21"/>
          <ac:graphicFrameMkLst>
            <pc:docMk/>
            <pc:sldMk cId="2013896836" sldId="257"/>
            <ac:graphicFrameMk id="14" creationId="{1179BCFE-A831-4629-B9E4-2F220BA966CF}"/>
          </ac:graphicFrameMkLst>
        </pc:graphicFrameChg>
        <pc:graphicFrameChg chg="add mod">
          <ac:chgData name="이선영" userId="91632b05-5949-44db-840d-a7fdc9de9d00" providerId="ADAL" clId="{EA729F21-364D-4F8F-87D4-42DDD6AE3364}" dt="2021-05-03T23:26:51.931" v="415" actId="403"/>
          <ac:graphicFrameMkLst>
            <pc:docMk/>
            <pc:sldMk cId="2013896836" sldId="257"/>
            <ac:graphicFrameMk id="15" creationId="{40269DEF-5F7A-49AF-9BF1-B7013EADC554}"/>
          </ac:graphicFrameMkLst>
        </pc:graphicFrameChg>
        <pc:graphicFrameChg chg="add mod">
          <ac:chgData name="이선영" userId="91632b05-5949-44db-840d-a7fdc9de9d00" providerId="ADAL" clId="{EA729F21-364D-4F8F-87D4-42DDD6AE3364}" dt="2021-05-03T23:26:55.384" v="416" actId="403"/>
          <ac:graphicFrameMkLst>
            <pc:docMk/>
            <pc:sldMk cId="2013896836" sldId="257"/>
            <ac:graphicFrameMk id="17" creationId="{E8F034B6-6B70-4FAC-81B1-AF14D0FDF545}"/>
          </ac:graphicFrameMkLst>
        </pc:graphicFrameChg>
      </pc:sldChg>
      <pc:sldChg chg="addSp delSp modSp mod">
        <pc:chgData name="이선영" userId="91632b05-5949-44db-840d-a7fdc9de9d00" providerId="ADAL" clId="{EA729F21-364D-4F8F-87D4-42DDD6AE3364}" dt="2021-05-06T12:05:29.002" v="808" actId="1076"/>
        <pc:sldMkLst>
          <pc:docMk/>
          <pc:sldMk cId="2451767308" sldId="258"/>
        </pc:sldMkLst>
        <pc:spChg chg="del">
          <ac:chgData name="이선영" userId="91632b05-5949-44db-840d-a7fdc9de9d00" providerId="ADAL" clId="{EA729F21-364D-4F8F-87D4-42DDD6AE3364}" dt="2021-05-03T23:10:14.419" v="182" actId="478"/>
          <ac:spMkLst>
            <pc:docMk/>
            <pc:sldMk cId="2451767308" sldId="258"/>
            <ac:spMk id="2" creationId="{00000000-0000-0000-0000-000000000000}"/>
          </ac:spMkLst>
        </pc:spChg>
        <pc:spChg chg="del">
          <ac:chgData name="이선영" userId="91632b05-5949-44db-840d-a7fdc9de9d00" providerId="ADAL" clId="{EA729F21-364D-4F8F-87D4-42DDD6AE3364}" dt="2021-05-03T23:10:13.246" v="181" actId="478"/>
          <ac:spMkLst>
            <pc:docMk/>
            <pc:sldMk cId="2451767308" sldId="258"/>
            <ac:spMk id="3" creationId="{00000000-0000-0000-0000-000000000000}"/>
          </ac:spMkLst>
        </pc:spChg>
        <pc:spChg chg="add del mod">
          <ac:chgData name="이선영" userId="91632b05-5949-44db-840d-a7fdc9de9d00" providerId="ADAL" clId="{EA729F21-364D-4F8F-87D4-42DDD6AE3364}" dt="2021-05-03T23:10:17.106" v="183" actId="478"/>
          <ac:spMkLst>
            <pc:docMk/>
            <pc:sldMk cId="2451767308" sldId="258"/>
            <ac:spMk id="7" creationId="{C3C6B179-4DBC-4B9A-8D3D-5A991CB680E2}"/>
          </ac:spMkLst>
        </pc:spChg>
        <pc:spChg chg="add mod">
          <ac:chgData name="이선영" userId="91632b05-5949-44db-840d-a7fdc9de9d00" providerId="ADAL" clId="{EA729F21-364D-4F8F-87D4-42DDD6AE3364}" dt="2021-05-03T23:10:40.210" v="190"/>
          <ac:spMkLst>
            <pc:docMk/>
            <pc:sldMk cId="2451767308" sldId="258"/>
            <ac:spMk id="8" creationId="{C52B5D9A-7BEB-4C2A-BF1F-AD7A22E8C0E0}"/>
          </ac:spMkLst>
        </pc:spChg>
        <pc:spChg chg="add mod">
          <ac:chgData name="이선영" userId="91632b05-5949-44db-840d-a7fdc9de9d00" providerId="ADAL" clId="{EA729F21-364D-4F8F-87D4-42DDD6AE3364}" dt="2021-05-03T23:10:40.210" v="190"/>
          <ac:spMkLst>
            <pc:docMk/>
            <pc:sldMk cId="2451767308" sldId="258"/>
            <ac:spMk id="9" creationId="{393C44A4-1644-4E2C-BD41-F03B85C29996}"/>
          </ac:spMkLst>
        </pc:spChg>
        <pc:spChg chg="add del mod">
          <ac:chgData name="이선영" userId="91632b05-5949-44db-840d-a7fdc9de9d00" providerId="ADAL" clId="{EA729F21-364D-4F8F-87D4-42DDD6AE3364}" dt="2021-05-06T12:05:22.999" v="805" actId="478"/>
          <ac:spMkLst>
            <pc:docMk/>
            <pc:sldMk cId="2451767308" sldId="258"/>
            <ac:spMk id="10" creationId="{A72100C0-0D69-4EF2-872A-0E750E3522DE}"/>
          </ac:spMkLst>
        </pc:spChg>
        <pc:spChg chg="add del mod">
          <ac:chgData name="이선영" userId="91632b05-5949-44db-840d-a7fdc9de9d00" providerId="ADAL" clId="{EA729F21-364D-4F8F-87D4-42DDD6AE3364}" dt="2021-05-06T12:05:22.999" v="805" actId="478"/>
          <ac:spMkLst>
            <pc:docMk/>
            <pc:sldMk cId="2451767308" sldId="258"/>
            <ac:spMk id="11" creationId="{F197E8FD-967C-463A-8C08-F07305E47869}"/>
          </ac:spMkLst>
        </pc:spChg>
        <pc:spChg chg="add mod">
          <ac:chgData name="이선영" userId="91632b05-5949-44db-840d-a7fdc9de9d00" providerId="ADAL" clId="{EA729F21-364D-4F8F-87D4-42DDD6AE3364}" dt="2021-05-03T23:10:46.659" v="199" actId="6549"/>
          <ac:spMkLst>
            <pc:docMk/>
            <pc:sldMk cId="2451767308" sldId="258"/>
            <ac:spMk id="12" creationId="{C206BE00-938E-45CC-8111-5CB8FB3F5C72}"/>
          </ac:spMkLst>
        </pc:spChg>
        <pc:spChg chg="add mod">
          <ac:chgData name="이선영" userId="91632b05-5949-44db-840d-a7fdc9de9d00" providerId="ADAL" clId="{EA729F21-364D-4F8F-87D4-42DDD6AE3364}" dt="2021-05-03T23:31:10.682" v="536" actId="20577"/>
          <ac:spMkLst>
            <pc:docMk/>
            <pc:sldMk cId="2451767308" sldId="258"/>
            <ac:spMk id="15" creationId="{65CD7099-6317-4875-866C-E8C25F15FE4D}"/>
          </ac:spMkLst>
        </pc:spChg>
        <pc:spChg chg="add mod">
          <ac:chgData name="이선영" userId="91632b05-5949-44db-840d-a7fdc9de9d00" providerId="ADAL" clId="{EA729F21-364D-4F8F-87D4-42DDD6AE3364}" dt="2021-05-03T23:31:15.379" v="540" actId="20577"/>
          <ac:spMkLst>
            <pc:docMk/>
            <pc:sldMk cId="2451767308" sldId="258"/>
            <ac:spMk id="16" creationId="{BAACB0D9-E805-46B1-92D0-67AF6318FE90}"/>
          </ac:spMkLst>
        </pc:spChg>
        <pc:spChg chg="add mod">
          <ac:chgData name="이선영" userId="91632b05-5949-44db-840d-a7fdc9de9d00" providerId="ADAL" clId="{EA729F21-364D-4F8F-87D4-42DDD6AE3364}" dt="2021-05-06T12:05:26.082" v="807" actId="1076"/>
          <ac:spMkLst>
            <pc:docMk/>
            <pc:sldMk cId="2451767308" sldId="258"/>
            <ac:spMk id="17" creationId="{2F335641-95D8-496C-8544-A1B569220EDD}"/>
          </ac:spMkLst>
        </pc:spChg>
        <pc:spChg chg="add mod">
          <ac:chgData name="이선영" userId="91632b05-5949-44db-840d-a7fdc9de9d00" providerId="ADAL" clId="{EA729F21-364D-4F8F-87D4-42DDD6AE3364}" dt="2021-05-06T12:05:29.002" v="808" actId="1076"/>
          <ac:spMkLst>
            <pc:docMk/>
            <pc:sldMk cId="2451767308" sldId="258"/>
            <ac:spMk id="18" creationId="{1DED0E11-6A85-4ED1-B1DC-6C4A203B9293}"/>
          </ac:spMkLst>
        </pc:spChg>
        <pc:graphicFrameChg chg="del mod">
          <ac:chgData name="이선영" userId="91632b05-5949-44db-840d-a7fdc9de9d00" providerId="ADAL" clId="{EA729F21-364D-4F8F-87D4-42DDD6AE3364}" dt="2021-05-03T23:27:59.201" v="431" actId="478"/>
          <ac:graphicFrameMkLst>
            <pc:docMk/>
            <pc:sldMk cId="2451767308" sldId="258"/>
            <ac:graphicFrameMk id="4" creationId="{DC12F60D-BC1A-4CCA-BF5C-2CEDEC844CC3}"/>
          </ac:graphicFrameMkLst>
        </pc:graphicFrameChg>
        <pc:graphicFrameChg chg="del mod">
          <ac:chgData name="이선영" userId="91632b05-5949-44db-840d-a7fdc9de9d00" providerId="ADAL" clId="{EA729F21-364D-4F8F-87D4-42DDD6AE3364}" dt="2021-05-03T23:27:59.201" v="431" actId="478"/>
          <ac:graphicFrameMkLst>
            <pc:docMk/>
            <pc:sldMk cId="2451767308" sldId="258"/>
            <ac:graphicFrameMk id="5" creationId="{FF28735C-920C-4E86-BBEA-CECA3E34D08D}"/>
          </ac:graphicFrameMkLst>
        </pc:graphicFrameChg>
        <pc:graphicFrameChg chg="add mod">
          <ac:chgData name="이선영" userId="91632b05-5949-44db-840d-a7fdc9de9d00" providerId="ADAL" clId="{EA729F21-364D-4F8F-87D4-42DDD6AE3364}" dt="2021-05-03T23:30:50.333" v="525" actId="403"/>
          <ac:graphicFrameMkLst>
            <pc:docMk/>
            <pc:sldMk cId="2451767308" sldId="258"/>
            <ac:graphicFrameMk id="13" creationId="{DC12F60D-BC1A-4CCA-BF5C-2CEDEC844CC3}"/>
          </ac:graphicFrameMkLst>
        </pc:graphicFrameChg>
        <pc:graphicFrameChg chg="add mod">
          <ac:chgData name="이선영" userId="91632b05-5949-44db-840d-a7fdc9de9d00" providerId="ADAL" clId="{EA729F21-364D-4F8F-87D4-42DDD6AE3364}" dt="2021-05-03T23:30:57.753" v="527" actId="14100"/>
          <ac:graphicFrameMkLst>
            <pc:docMk/>
            <pc:sldMk cId="2451767308" sldId="258"/>
            <ac:graphicFrameMk id="14" creationId="{FF28735C-920C-4E86-BBEA-CECA3E34D08D}"/>
          </ac:graphicFrameMkLst>
        </pc:graphicFrameChg>
      </pc:sldChg>
      <pc:sldChg chg="addSp delSp modSp mod">
        <pc:chgData name="이선영" userId="91632b05-5949-44db-840d-a7fdc9de9d00" providerId="ADAL" clId="{EA729F21-364D-4F8F-87D4-42DDD6AE3364}" dt="2021-05-06T12:05:41.324" v="813" actId="1076"/>
        <pc:sldMkLst>
          <pc:docMk/>
          <pc:sldMk cId="1770555727" sldId="259"/>
        </pc:sldMkLst>
        <pc:spChg chg="del">
          <ac:chgData name="이선영" userId="91632b05-5949-44db-840d-a7fdc9de9d00" providerId="ADAL" clId="{EA729F21-364D-4F8F-87D4-42DDD6AE3364}" dt="2021-05-03T23:10:53.747" v="200" actId="478"/>
          <ac:spMkLst>
            <pc:docMk/>
            <pc:sldMk cId="1770555727" sldId="259"/>
            <ac:spMk id="2" creationId="{00000000-0000-0000-0000-000000000000}"/>
          </ac:spMkLst>
        </pc:spChg>
        <pc:spChg chg="del">
          <ac:chgData name="이선영" userId="91632b05-5949-44db-840d-a7fdc9de9d00" providerId="ADAL" clId="{EA729F21-364D-4F8F-87D4-42DDD6AE3364}" dt="2021-05-03T23:10:53.747" v="200" actId="478"/>
          <ac:spMkLst>
            <pc:docMk/>
            <pc:sldMk cId="1770555727" sldId="259"/>
            <ac:spMk id="3" creationId="{00000000-0000-0000-0000-000000000000}"/>
          </ac:spMkLst>
        </pc:spChg>
        <pc:spChg chg="add del mod">
          <ac:chgData name="이선영" userId="91632b05-5949-44db-840d-a7fdc9de9d00" providerId="ADAL" clId="{EA729F21-364D-4F8F-87D4-42DDD6AE3364}" dt="2021-05-03T23:10:56.160" v="202" actId="478"/>
          <ac:spMkLst>
            <pc:docMk/>
            <pc:sldMk cId="1770555727" sldId="259"/>
            <ac:spMk id="7" creationId="{CD304571-5089-4D2E-8A03-10039156BE98}"/>
          </ac:spMkLst>
        </pc:spChg>
        <pc:spChg chg="add mod">
          <ac:chgData name="이선영" userId="91632b05-5949-44db-840d-a7fdc9de9d00" providerId="ADAL" clId="{EA729F21-364D-4F8F-87D4-42DDD6AE3364}" dt="2021-05-03T23:10:54.199" v="201"/>
          <ac:spMkLst>
            <pc:docMk/>
            <pc:sldMk cId="1770555727" sldId="259"/>
            <ac:spMk id="8" creationId="{929F9B78-AE72-4FA9-B534-6BC7C89FEEAE}"/>
          </ac:spMkLst>
        </pc:spChg>
        <pc:spChg chg="add mod">
          <ac:chgData name="이선영" userId="91632b05-5949-44db-840d-a7fdc9de9d00" providerId="ADAL" clId="{EA729F21-364D-4F8F-87D4-42DDD6AE3364}" dt="2021-05-03T23:10:54.199" v="201"/>
          <ac:spMkLst>
            <pc:docMk/>
            <pc:sldMk cId="1770555727" sldId="259"/>
            <ac:spMk id="9" creationId="{12D74F4E-8545-4B71-86E6-2A3E4F47E38C}"/>
          </ac:spMkLst>
        </pc:spChg>
        <pc:spChg chg="add del mod">
          <ac:chgData name="이선영" userId="91632b05-5949-44db-840d-a7fdc9de9d00" providerId="ADAL" clId="{EA729F21-364D-4F8F-87D4-42DDD6AE3364}" dt="2021-05-06T12:05:34.011" v="809" actId="478"/>
          <ac:spMkLst>
            <pc:docMk/>
            <pc:sldMk cId="1770555727" sldId="259"/>
            <ac:spMk id="10" creationId="{2C01B287-DE27-4A41-985B-C24FC43DC512}"/>
          </ac:spMkLst>
        </pc:spChg>
        <pc:spChg chg="add del mod">
          <ac:chgData name="이선영" userId="91632b05-5949-44db-840d-a7fdc9de9d00" providerId="ADAL" clId="{EA729F21-364D-4F8F-87D4-42DDD6AE3364}" dt="2021-05-06T12:05:34.011" v="809" actId="478"/>
          <ac:spMkLst>
            <pc:docMk/>
            <pc:sldMk cId="1770555727" sldId="259"/>
            <ac:spMk id="11" creationId="{F20599C5-F3D8-4F09-9612-7C47D286C530}"/>
          </ac:spMkLst>
        </pc:spChg>
        <pc:spChg chg="add mod">
          <ac:chgData name="이선영" userId="91632b05-5949-44db-840d-a7fdc9de9d00" providerId="ADAL" clId="{EA729F21-364D-4F8F-87D4-42DDD6AE3364}" dt="2021-05-03T23:11:04.920" v="231" actId="6549"/>
          <ac:spMkLst>
            <pc:docMk/>
            <pc:sldMk cId="1770555727" sldId="259"/>
            <ac:spMk id="12" creationId="{3D775711-48F7-433D-969B-07D64223008F}"/>
          </ac:spMkLst>
        </pc:spChg>
        <pc:spChg chg="add mod">
          <ac:chgData name="이선영" userId="91632b05-5949-44db-840d-a7fdc9de9d00" providerId="ADAL" clId="{EA729F21-364D-4F8F-87D4-42DDD6AE3364}" dt="2021-05-03T23:31:48.277" v="559" actId="20577"/>
          <ac:spMkLst>
            <pc:docMk/>
            <pc:sldMk cId="1770555727" sldId="259"/>
            <ac:spMk id="15" creationId="{DA5C840A-8A8F-4911-8ED6-DA10580A8ECE}"/>
          </ac:spMkLst>
        </pc:spChg>
        <pc:spChg chg="add mod">
          <ac:chgData name="이선영" userId="91632b05-5949-44db-840d-a7fdc9de9d00" providerId="ADAL" clId="{EA729F21-364D-4F8F-87D4-42DDD6AE3364}" dt="2021-05-03T23:31:52.974" v="561" actId="20577"/>
          <ac:spMkLst>
            <pc:docMk/>
            <pc:sldMk cId="1770555727" sldId="259"/>
            <ac:spMk id="16" creationId="{BC1EFCF7-13BC-4509-8B5B-4D5CA558056F}"/>
          </ac:spMkLst>
        </pc:spChg>
        <pc:spChg chg="add mod">
          <ac:chgData name="이선영" userId="91632b05-5949-44db-840d-a7fdc9de9d00" providerId="ADAL" clId="{EA729F21-364D-4F8F-87D4-42DDD6AE3364}" dt="2021-05-06T12:05:41.324" v="813" actId="1076"/>
          <ac:spMkLst>
            <pc:docMk/>
            <pc:sldMk cId="1770555727" sldId="259"/>
            <ac:spMk id="17" creationId="{FB142F8C-CFA2-471F-8B41-349A7512138E}"/>
          </ac:spMkLst>
        </pc:spChg>
        <pc:spChg chg="add mod">
          <ac:chgData name="이선영" userId="91632b05-5949-44db-840d-a7fdc9de9d00" providerId="ADAL" clId="{EA729F21-364D-4F8F-87D4-42DDD6AE3364}" dt="2021-05-06T12:05:41.324" v="813" actId="1076"/>
          <ac:spMkLst>
            <pc:docMk/>
            <pc:sldMk cId="1770555727" sldId="259"/>
            <ac:spMk id="18" creationId="{E4285F0C-81CE-4134-847A-9BBAE0730FF2}"/>
          </ac:spMkLst>
        </pc:spChg>
        <pc:graphicFrameChg chg="del mod">
          <ac:chgData name="이선영" userId="91632b05-5949-44db-840d-a7fdc9de9d00" providerId="ADAL" clId="{EA729F21-364D-4F8F-87D4-42DDD6AE3364}" dt="2021-05-03T23:28:12.735" v="436" actId="478"/>
          <ac:graphicFrameMkLst>
            <pc:docMk/>
            <pc:sldMk cId="1770555727" sldId="259"/>
            <ac:graphicFrameMk id="4" creationId="{2FDE0657-B4C0-4A52-A433-4BA987284A46}"/>
          </ac:graphicFrameMkLst>
        </pc:graphicFrameChg>
        <pc:graphicFrameChg chg="del mod">
          <ac:chgData name="이선영" userId="91632b05-5949-44db-840d-a7fdc9de9d00" providerId="ADAL" clId="{EA729F21-364D-4F8F-87D4-42DDD6AE3364}" dt="2021-05-03T23:28:12.735" v="436" actId="478"/>
          <ac:graphicFrameMkLst>
            <pc:docMk/>
            <pc:sldMk cId="1770555727" sldId="259"/>
            <ac:graphicFrameMk id="5" creationId="{F8B9C52F-16B2-4024-8F29-177E7D455C33}"/>
          </ac:graphicFrameMkLst>
        </pc:graphicFrameChg>
        <pc:graphicFrameChg chg="add mod">
          <ac:chgData name="이선영" userId="91632b05-5949-44db-840d-a7fdc9de9d00" providerId="ADAL" clId="{EA729F21-364D-4F8F-87D4-42DDD6AE3364}" dt="2021-05-03T23:31:22.855" v="544" actId="403"/>
          <ac:graphicFrameMkLst>
            <pc:docMk/>
            <pc:sldMk cId="1770555727" sldId="259"/>
            <ac:graphicFrameMk id="13" creationId="{2FDE0657-B4C0-4A52-A433-4BA987284A46}"/>
          </ac:graphicFrameMkLst>
        </pc:graphicFrameChg>
        <pc:graphicFrameChg chg="add mod">
          <ac:chgData name="이선영" userId="91632b05-5949-44db-840d-a7fdc9de9d00" providerId="ADAL" clId="{EA729F21-364D-4F8F-87D4-42DDD6AE3364}" dt="2021-05-03T23:31:30.687" v="548" actId="403"/>
          <ac:graphicFrameMkLst>
            <pc:docMk/>
            <pc:sldMk cId="1770555727" sldId="259"/>
            <ac:graphicFrameMk id="14" creationId="{F8B9C52F-16B2-4024-8F29-177E7D455C33}"/>
          </ac:graphicFrameMkLst>
        </pc:graphicFrameChg>
      </pc:sldChg>
      <pc:sldChg chg="addSp delSp modSp mod modNotesTx">
        <pc:chgData name="이선영" userId="91632b05-5949-44db-840d-a7fdc9de9d00" providerId="ADAL" clId="{EA729F21-364D-4F8F-87D4-42DDD6AE3364}" dt="2021-05-06T12:05:19.726" v="804" actId="1076"/>
        <pc:sldMkLst>
          <pc:docMk/>
          <pc:sldMk cId="2494166487" sldId="260"/>
        </pc:sldMkLst>
        <pc:spChg chg="del mod">
          <ac:chgData name="이선영" userId="91632b05-5949-44db-840d-a7fdc9de9d00" providerId="ADAL" clId="{EA729F21-364D-4F8F-87D4-42DDD6AE3364}" dt="2021-05-03T23:09:56.590" v="176" actId="478"/>
          <ac:spMkLst>
            <pc:docMk/>
            <pc:sldMk cId="2494166487" sldId="260"/>
            <ac:spMk id="2" creationId="{00000000-0000-0000-0000-000000000000}"/>
          </ac:spMkLst>
        </pc:spChg>
        <pc:spChg chg="del">
          <ac:chgData name="이선영" userId="91632b05-5949-44db-840d-a7fdc9de9d00" providerId="ADAL" clId="{EA729F21-364D-4F8F-87D4-42DDD6AE3364}" dt="2021-05-03T23:08:50.486" v="127" actId="478"/>
          <ac:spMkLst>
            <pc:docMk/>
            <pc:sldMk cId="2494166487" sldId="260"/>
            <ac:spMk id="3" creationId="{00000000-0000-0000-0000-000000000000}"/>
          </ac:spMkLst>
        </pc:spChg>
        <pc:spChg chg="add mod">
          <ac:chgData name="이선영" userId="91632b05-5949-44db-840d-a7fdc9de9d00" providerId="ADAL" clId="{EA729F21-364D-4F8F-87D4-42DDD6AE3364}" dt="2021-05-03T23:10:03.306" v="179" actId="20577"/>
          <ac:spMkLst>
            <pc:docMk/>
            <pc:sldMk cId="2494166487" sldId="260"/>
            <ac:spMk id="6" creationId="{6258BEC3-096D-4159-A377-4BEFA416BD08}"/>
          </ac:spMkLst>
        </pc:spChg>
        <pc:spChg chg="add mod">
          <ac:chgData name="이선영" userId="91632b05-5949-44db-840d-a7fdc9de9d00" providerId="ADAL" clId="{EA729F21-364D-4F8F-87D4-42DDD6AE3364}" dt="2021-05-03T23:10:06.767" v="180" actId="20577"/>
          <ac:spMkLst>
            <pc:docMk/>
            <pc:sldMk cId="2494166487" sldId="260"/>
            <ac:spMk id="7" creationId="{62C0C70E-BCB4-4938-977A-8AFC965F53E4}"/>
          </ac:spMkLst>
        </pc:spChg>
        <pc:spChg chg="add del mod">
          <ac:chgData name="이선영" userId="91632b05-5949-44db-840d-a7fdc9de9d00" providerId="ADAL" clId="{EA729F21-364D-4F8F-87D4-42DDD6AE3364}" dt="2021-05-06T12:05:16.324" v="802" actId="478"/>
          <ac:spMkLst>
            <pc:docMk/>
            <pc:sldMk cId="2494166487" sldId="260"/>
            <ac:spMk id="8" creationId="{06F73A72-F3DC-4404-90FB-E4F43583DE78}"/>
          </ac:spMkLst>
        </pc:spChg>
        <pc:spChg chg="add del mod">
          <ac:chgData name="이선영" userId="91632b05-5949-44db-840d-a7fdc9de9d00" providerId="ADAL" clId="{EA729F21-364D-4F8F-87D4-42DDD6AE3364}" dt="2021-05-06T12:05:16.324" v="802" actId="478"/>
          <ac:spMkLst>
            <pc:docMk/>
            <pc:sldMk cId="2494166487" sldId="260"/>
            <ac:spMk id="9" creationId="{E412AFDC-F848-4C6C-BDEA-C1E727830F60}"/>
          </ac:spMkLst>
        </pc:spChg>
        <pc:spChg chg="add mod">
          <ac:chgData name="이선영" userId="91632b05-5949-44db-840d-a7fdc9de9d00" providerId="ADAL" clId="{EA729F21-364D-4F8F-87D4-42DDD6AE3364}" dt="2021-05-03T23:10:01.797" v="178" actId="1076"/>
          <ac:spMkLst>
            <pc:docMk/>
            <pc:sldMk cId="2494166487" sldId="260"/>
            <ac:spMk id="10" creationId="{6B2E839F-E783-44C1-856A-425B3D7E3342}"/>
          </ac:spMkLst>
        </pc:spChg>
        <pc:spChg chg="add mod">
          <ac:chgData name="이선영" userId="91632b05-5949-44db-840d-a7fdc9de9d00" providerId="ADAL" clId="{EA729F21-364D-4F8F-87D4-42DDD6AE3364}" dt="2021-05-06T12:05:19.726" v="804" actId="1076"/>
          <ac:spMkLst>
            <pc:docMk/>
            <pc:sldMk cId="2494166487" sldId="260"/>
            <ac:spMk id="11" creationId="{024403D3-A322-4999-96E1-E5308B66F529}"/>
          </ac:spMkLst>
        </pc:spChg>
        <pc:spChg chg="add mod">
          <ac:chgData name="이선영" userId="91632b05-5949-44db-840d-a7fdc9de9d00" providerId="ADAL" clId="{EA729F21-364D-4F8F-87D4-42DDD6AE3364}" dt="2021-05-06T12:05:19.726" v="804" actId="1076"/>
          <ac:spMkLst>
            <pc:docMk/>
            <pc:sldMk cId="2494166487" sldId="260"/>
            <ac:spMk id="12" creationId="{0826A855-CD3B-496C-A04B-938EE0622378}"/>
          </ac:spMkLst>
        </pc:spChg>
        <pc:spChg chg="add del mod">
          <ac:chgData name="이선영" userId="91632b05-5949-44db-840d-a7fdc9de9d00" providerId="ADAL" clId="{EA729F21-364D-4F8F-87D4-42DDD6AE3364}" dt="2021-05-03T23:09:58.436" v="177" actId="478"/>
          <ac:spMkLst>
            <pc:docMk/>
            <pc:sldMk cId="2494166487" sldId="260"/>
            <ac:spMk id="12" creationId="{B2FA7F2D-5721-4706-87B0-9D900985789B}"/>
          </ac:spMkLst>
        </pc:spChg>
        <pc:spChg chg="add mod">
          <ac:chgData name="이선영" userId="91632b05-5949-44db-840d-a7fdc9de9d00" providerId="ADAL" clId="{EA729F21-364D-4F8F-87D4-42DDD6AE3364}" dt="2021-05-03T23:29:43.900" v="477" actId="20577"/>
          <ac:spMkLst>
            <pc:docMk/>
            <pc:sldMk cId="2494166487" sldId="260"/>
            <ac:spMk id="15" creationId="{A938510A-8722-46E7-BFB0-BFF7CFF87979}"/>
          </ac:spMkLst>
        </pc:spChg>
        <pc:spChg chg="add mod">
          <ac:chgData name="이선영" userId="91632b05-5949-44db-840d-a7fdc9de9d00" providerId="ADAL" clId="{EA729F21-364D-4F8F-87D4-42DDD6AE3364}" dt="2021-05-03T23:30:31.590" v="518" actId="6549"/>
          <ac:spMkLst>
            <pc:docMk/>
            <pc:sldMk cId="2494166487" sldId="260"/>
            <ac:spMk id="16" creationId="{7241A92C-4AD5-4FD4-A293-6E94E32DDFF4}"/>
          </ac:spMkLst>
        </pc:spChg>
        <pc:graphicFrameChg chg="del mod">
          <ac:chgData name="이선영" userId="91632b05-5949-44db-840d-a7fdc9de9d00" providerId="ADAL" clId="{EA729F21-364D-4F8F-87D4-42DDD6AE3364}" dt="2021-05-03T23:27:27.832" v="418" actId="478"/>
          <ac:graphicFrameMkLst>
            <pc:docMk/>
            <pc:sldMk cId="2494166487" sldId="260"/>
            <ac:graphicFrameMk id="4" creationId="{01C5F93A-0C23-4E41-A097-8110603840B4}"/>
          </ac:graphicFrameMkLst>
        </pc:graphicFrameChg>
        <pc:graphicFrameChg chg="del mod">
          <ac:chgData name="이선영" userId="91632b05-5949-44db-840d-a7fdc9de9d00" providerId="ADAL" clId="{EA729F21-364D-4F8F-87D4-42DDD6AE3364}" dt="2021-05-03T23:27:27.832" v="418" actId="478"/>
          <ac:graphicFrameMkLst>
            <pc:docMk/>
            <pc:sldMk cId="2494166487" sldId="260"/>
            <ac:graphicFrameMk id="5" creationId="{38F10562-4682-41C7-8CF7-E6B07F7DA186}"/>
          </ac:graphicFrameMkLst>
        </pc:graphicFrameChg>
        <pc:graphicFrameChg chg="add mod">
          <ac:chgData name="이선영" userId="91632b05-5949-44db-840d-a7fdc9de9d00" providerId="ADAL" clId="{EA729F21-364D-4F8F-87D4-42DDD6AE3364}" dt="2021-05-03T23:27:45.928" v="428" actId="403"/>
          <ac:graphicFrameMkLst>
            <pc:docMk/>
            <pc:sldMk cId="2494166487" sldId="260"/>
            <ac:graphicFrameMk id="13" creationId="{01C5F93A-0C23-4E41-A097-8110603840B4}"/>
          </ac:graphicFrameMkLst>
        </pc:graphicFrameChg>
        <pc:graphicFrameChg chg="add mod">
          <ac:chgData name="이선영" userId="91632b05-5949-44db-840d-a7fdc9de9d00" providerId="ADAL" clId="{EA729F21-364D-4F8F-87D4-42DDD6AE3364}" dt="2021-05-03T23:30:10.472" v="485" actId="1076"/>
          <ac:graphicFrameMkLst>
            <pc:docMk/>
            <pc:sldMk cId="2494166487" sldId="260"/>
            <ac:graphicFrameMk id="14" creationId="{38F10562-4682-41C7-8CF7-E6B07F7DA186}"/>
          </ac:graphicFrameMkLst>
        </pc:graphicFrameChg>
      </pc:sldChg>
      <pc:sldChg chg="addSp delSp modSp mod">
        <pc:chgData name="이선영" userId="91632b05-5949-44db-840d-a7fdc9de9d00" providerId="ADAL" clId="{EA729F21-364D-4F8F-87D4-42DDD6AE3364}" dt="2021-05-06T12:05:54.313" v="818"/>
        <pc:sldMkLst>
          <pc:docMk/>
          <pc:sldMk cId="1728432787" sldId="261"/>
        </pc:sldMkLst>
        <pc:spChg chg="del">
          <ac:chgData name="이선영" userId="91632b05-5949-44db-840d-a7fdc9de9d00" providerId="ADAL" clId="{EA729F21-364D-4F8F-87D4-42DDD6AE3364}" dt="2021-05-03T23:12:38.105" v="265" actId="478"/>
          <ac:spMkLst>
            <pc:docMk/>
            <pc:sldMk cId="1728432787" sldId="261"/>
            <ac:spMk id="2" creationId="{00000000-0000-0000-0000-000000000000}"/>
          </ac:spMkLst>
        </pc:spChg>
        <pc:spChg chg="del">
          <ac:chgData name="이선영" userId="91632b05-5949-44db-840d-a7fdc9de9d00" providerId="ADAL" clId="{EA729F21-364D-4F8F-87D4-42DDD6AE3364}" dt="2021-05-03T23:12:38.105" v="265" actId="478"/>
          <ac:spMkLst>
            <pc:docMk/>
            <pc:sldMk cId="1728432787" sldId="261"/>
            <ac:spMk id="3" creationId="{00000000-0000-0000-0000-000000000000}"/>
          </ac:spMkLst>
        </pc:spChg>
        <pc:spChg chg="add del mod">
          <ac:chgData name="이선영" userId="91632b05-5949-44db-840d-a7fdc9de9d00" providerId="ADAL" clId="{EA729F21-364D-4F8F-87D4-42DDD6AE3364}" dt="2021-05-03T23:12:40.883" v="266" actId="478"/>
          <ac:spMkLst>
            <pc:docMk/>
            <pc:sldMk cId="1728432787" sldId="261"/>
            <ac:spMk id="7" creationId="{AC77C2D4-5E18-4267-A401-E6A8435DFAEA}"/>
          </ac:spMkLst>
        </pc:spChg>
        <pc:spChg chg="add mod">
          <ac:chgData name="이선영" userId="91632b05-5949-44db-840d-a7fdc9de9d00" providerId="ADAL" clId="{EA729F21-364D-4F8F-87D4-42DDD6AE3364}" dt="2021-05-03T23:12:41.430" v="267"/>
          <ac:spMkLst>
            <pc:docMk/>
            <pc:sldMk cId="1728432787" sldId="261"/>
            <ac:spMk id="8" creationId="{5CBDD246-36DA-4B60-A958-FFAE9DEB4479}"/>
          </ac:spMkLst>
        </pc:spChg>
        <pc:spChg chg="add mod">
          <ac:chgData name="이선영" userId="91632b05-5949-44db-840d-a7fdc9de9d00" providerId="ADAL" clId="{EA729F21-364D-4F8F-87D4-42DDD6AE3364}" dt="2021-05-03T23:12:41.430" v="267"/>
          <ac:spMkLst>
            <pc:docMk/>
            <pc:sldMk cId="1728432787" sldId="261"/>
            <ac:spMk id="9" creationId="{23D3C1C4-F26E-440A-B7F9-0478BA1AA812}"/>
          </ac:spMkLst>
        </pc:spChg>
        <pc:spChg chg="add del mod">
          <ac:chgData name="이선영" userId="91632b05-5949-44db-840d-a7fdc9de9d00" providerId="ADAL" clId="{EA729F21-364D-4F8F-87D4-42DDD6AE3364}" dt="2021-05-06T12:05:53.968" v="817" actId="478"/>
          <ac:spMkLst>
            <pc:docMk/>
            <pc:sldMk cId="1728432787" sldId="261"/>
            <ac:spMk id="10" creationId="{A97A7720-747D-46BB-8988-B81EE6FE21BB}"/>
          </ac:spMkLst>
        </pc:spChg>
        <pc:spChg chg="add del mod">
          <ac:chgData name="이선영" userId="91632b05-5949-44db-840d-a7fdc9de9d00" providerId="ADAL" clId="{EA729F21-364D-4F8F-87D4-42DDD6AE3364}" dt="2021-05-06T12:05:53.968" v="817" actId="478"/>
          <ac:spMkLst>
            <pc:docMk/>
            <pc:sldMk cId="1728432787" sldId="261"/>
            <ac:spMk id="11" creationId="{DE337432-E778-4055-9451-401A2D2D9D26}"/>
          </ac:spMkLst>
        </pc:spChg>
        <pc:spChg chg="add mod">
          <ac:chgData name="이선영" userId="91632b05-5949-44db-840d-a7fdc9de9d00" providerId="ADAL" clId="{EA729F21-364D-4F8F-87D4-42DDD6AE3364}" dt="2021-05-03T23:12:47.561" v="284" actId="6549"/>
          <ac:spMkLst>
            <pc:docMk/>
            <pc:sldMk cId="1728432787" sldId="261"/>
            <ac:spMk id="12" creationId="{9EB93F7F-EA24-4C46-BB01-0D058E7816F6}"/>
          </ac:spMkLst>
        </pc:spChg>
        <pc:spChg chg="add mod">
          <ac:chgData name="이선영" userId="91632b05-5949-44db-840d-a7fdc9de9d00" providerId="ADAL" clId="{EA729F21-364D-4F8F-87D4-42DDD6AE3364}" dt="2021-05-03T23:33:05.156" v="608" actId="20577"/>
          <ac:spMkLst>
            <pc:docMk/>
            <pc:sldMk cId="1728432787" sldId="261"/>
            <ac:spMk id="15" creationId="{CB2F02FD-9250-43FC-BFFF-43BEA9F0CB9F}"/>
          </ac:spMkLst>
        </pc:spChg>
        <pc:spChg chg="add mod">
          <ac:chgData name="이선영" userId="91632b05-5949-44db-840d-a7fdc9de9d00" providerId="ADAL" clId="{EA729F21-364D-4F8F-87D4-42DDD6AE3364}" dt="2021-05-03T23:33:13.605" v="624" actId="20577"/>
          <ac:spMkLst>
            <pc:docMk/>
            <pc:sldMk cId="1728432787" sldId="261"/>
            <ac:spMk id="16" creationId="{9C13E8E6-A416-4F7C-82D7-AE29FCF94C41}"/>
          </ac:spMkLst>
        </pc:spChg>
        <pc:spChg chg="add mod">
          <ac:chgData name="이선영" userId="91632b05-5949-44db-840d-a7fdc9de9d00" providerId="ADAL" clId="{EA729F21-364D-4F8F-87D4-42DDD6AE3364}" dt="2021-05-06T12:05:54.313" v="818"/>
          <ac:spMkLst>
            <pc:docMk/>
            <pc:sldMk cId="1728432787" sldId="261"/>
            <ac:spMk id="17" creationId="{81768B31-B320-44CD-BBCE-C7585D82C2E8}"/>
          </ac:spMkLst>
        </pc:spChg>
        <pc:spChg chg="add mod">
          <ac:chgData name="이선영" userId="91632b05-5949-44db-840d-a7fdc9de9d00" providerId="ADAL" clId="{EA729F21-364D-4F8F-87D4-42DDD6AE3364}" dt="2021-05-06T12:05:54.313" v="818"/>
          <ac:spMkLst>
            <pc:docMk/>
            <pc:sldMk cId="1728432787" sldId="261"/>
            <ac:spMk id="18" creationId="{E2C6F5E5-B089-47EE-BE37-2F6D4F0472A5}"/>
          </ac:spMkLst>
        </pc:spChg>
        <pc:graphicFrameChg chg="del mod">
          <ac:chgData name="이선영" userId="91632b05-5949-44db-840d-a7fdc9de9d00" providerId="ADAL" clId="{EA729F21-364D-4F8F-87D4-42DDD6AE3364}" dt="2021-05-03T23:28:32.985" v="446" actId="478"/>
          <ac:graphicFrameMkLst>
            <pc:docMk/>
            <pc:sldMk cId="1728432787" sldId="261"/>
            <ac:graphicFrameMk id="4" creationId="{FE45F6FF-9B6D-4407-B664-4A2547F9F378}"/>
          </ac:graphicFrameMkLst>
        </pc:graphicFrameChg>
        <pc:graphicFrameChg chg="del mod">
          <ac:chgData name="이선영" userId="91632b05-5949-44db-840d-a7fdc9de9d00" providerId="ADAL" clId="{EA729F21-364D-4F8F-87D4-42DDD6AE3364}" dt="2021-05-03T23:28:32.985" v="446" actId="478"/>
          <ac:graphicFrameMkLst>
            <pc:docMk/>
            <pc:sldMk cId="1728432787" sldId="261"/>
            <ac:graphicFrameMk id="5" creationId="{33DA60E6-2BCD-4E12-A6CF-D0F1E118904F}"/>
          </ac:graphicFrameMkLst>
        </pc:graphicFrameChg>
        <pc:graphicFrameChg chg="add mod">
          <ac:chgData name="이선영" userId="91632b05-5949-44db-840d-a7fdc9de9d00" providerId="ADAL" clId="{EA729F21-364D-4F8F-87D4-42DDD6AE3364}" dt="2021-05-03T23:32:49.547" v="591" actId="14100"/>
          <ac:graphicFrameMkLst>
            <pc:docMk/>
            <pc:sldMk cId="1728432787" sldId="261"/>
            <ac:graphicFrameMk id="13" creationId="{FE45F6FF-9B6D-4407-B664-4A2547F9F378}"/>
          </ac:graphicFrameMkLst>
        </pc:graphicFrameChg>
        <pc:graphicFrameChg chg="add mod">
          <ac:chgData name="이선영" userId="91632b05-5949-44db-840d-a7fdc9de9d00" providerId="ADAL" clId="{EA729F21-364D-4F8F-87D4-42DDD6AE3364}" dt="2021-05-03T23:32:56.611" v="595" actId="403"/>
          <ac:graphicFrameMkLst>
            <pc:docMk/>
            <pc:sldMk cId="1728432787" sldId="261"/>
            <ac:graphicFrameMk id="14" creationId="{33DA60E6-2BCD-4E12-A6CF-D0F1E118904F}"/>
          </ac:graphicFrameMkLst>
        </pc:graphicFrameChg>
      </pc:sldChg>
      <pc:sldChg chg="addSp delSp modSp mod">
        <pc:chgData name="이선영" userId="91632b05-5949-44db-840d-a7fdc9de9d00" providerId="ADAL" clId="{EA729F21-364D-4F8F-87D4-42DDD6AE3364}" dt="2021-05-06T12:05:50.352" v="816" actId="1076"/>
        <pc:sldMkLst>
          <pc:docMk/>
          <pc:sldMk cId="3509119941" sldId="262"/>
        </pc:sldMkLst>
        <pc:spChg chg="del">
          <ac:chgData name="이선영" userId="91632b05-5949-44db-840d-a7fdc9de9d00" providerId="ADAL" clId="{EA729F21-364D-4F8F-87D4-42DDD6AE3364}" dt="2021-05-03T23:12:03.750" v="236" actId="478"/>
          <ac:spMkLst>
            <pc:docMk/>
            <pc:sldMk cId="3509119941" sldId="262"/>
            <ac:spMk id="2" creationId="{00000000-0000-0000-0000-000000000000}"/>
          </ac:spMkLst>
        </pc:spChg>
        <pc:spChg chg="del">
          <ac:chgData name="이선영" userId="91632b05-5949-44db-840d-a7fdc9de9d00" providerId="ADAL" clId="{EA729F21-364D-4F8F-87D4-42DDD6AE3364}" dt="2021-05-03T23:12:03.750" v="236" actId="478"/>
          <ac:spMkLst>
            <pc:docMk/>
            <pc:sldMk cId="3509119941" sldId="262"/>
            <ac:spMk id="3" creationId="{00000000-0000-0000-0000-000000000000}"/>
          </ac:spMkLst>
        </pc:spChg>
        <pc:spChg chg="add del mod">
          <ac:chgData name="이선영" userId="91632b05-5949-44db-840d-a7fdc9de9d00" providerId="ADAL" clId="{EA729F21-364D-4F8F-87D4-42DDD6AE3364}" dt="2021-05-03T23:12:06.221" v="237" actId="478"/>
          <ac:spMkLst>
            <pc:docMk/>
            <pc:sldMk cId="3509119941" sldId="262"/>
            <ac:spMk id="7" creationId="{92BA1339-9CCE-4ABB-A39A-40353B3FFD25}"/>
          </ac:spMkLst>
        </pc:spChg>
        <pc:spChg chg="add mod">
          <ac:chgData name="이선영" userId="91632b05-5949-44db-840d-a7fdc9de9d00" providerId="ADAL" clId="{EA729F21-364D-4F8F-87D4-42DDD6AE3364}" dt="2021-05-03T23:12:07.303" v="238"/>
          <ac:spMkLst>
            <pc:docMk/>
            <pc:sldMk cId="3509119941" sldId="262"/>
            <ac:spMk id="8" creationId="{9A50F11A-89E4-46D5-9DAD-19CBB5F42823}"/>
          </ac:spMkLst>
        </pc:spChg>
        <pc:spChg chg="add mod">
          <ac:chgData name="이선영" userId="91632b05-5949-44db-840d-a7fdc9de9d00" providerId="ADAL" clId="{EA729F21-364D-4F8F-87D4-42DDD6AE3364}" dt="2021-05-03T23:12:07.303" v="238"/>
          <ac:spMkLst>
            <pc:docMk/>
            <pc:sldMk cId="3509119941" sldId="262"/>
            <ac:spMk id="9" creationId="{ACFED96E-3ED9-40B4-924A-487610437B48}"/>
          </ac:spMkLst>
        </pc:spChg>
        <pc:spChg chg="add del mod">
          <ac:chgData name="이선영" userId="91632b05-5949-44db-840d-a7fdc9de9d00" providerId="ADAL" clId="{EA729F21-364D-4F8F-87D4-42DDD6AE3364}" dt="2021-05-06T12:05:45.696" v="814" actId="478"/>
          <ac:spMkLst>
            <pc:docMk/>
            <pc:sldMk cId="3509119941" sldId="262"/>
            <ac:spMk id="10" creationId="{57E62FB0-E76D-4F75-848A-658E3DE42168}"/>
          </ac:spMkLst>
        </pc:spChg>
        <pc:spChg chg="add del mod">
          <ac:chgData name="이선영" userId="91632b05-5949-44db-840d-a7fdc9de9d00" providerId="ADAL" clId="{EA729F21-364D-4F8F-87D4-42DDD6AE3364}" dt="2021-05-06T12:05:45.696" v="814" actId="478"/>
          <ac:spMkLst>
            <pc:docMk/>
            <pc:sldMk cId="3509119941" sldId="262"/>
            <ac:spMk id="11" creationId="{0BB5BCEC-70ED-40CB-A152-36ADC215BA3B}"/>
          </ac:spMkLst>
        </pc:spChg>
        <pc:spChg chg="add mod">
          <ac:chgData name="이선영" userId="91632b05-5949-44db-840d-a7fdc9de9d00" providerId="ADAL" clId="{EA729F21-364D-4F8F-87D4-42DDD6AE3364}" dt="2021-05-03T23:12:13.263" v="257" actId="6549"/>
          <ac:spMkLst>
            <pc:docMk/>
            <pc:sldMk cId="3509119941" sldId="262"/>
            <ac:spMk id="12" creationId="{F0B3F02F-2967-4FB8-BF80-03DDAB621382}"/>
          </ac:spMkLst>
        </pc:spChg>
        <pc:spChg chg="add mod">
          <ac:chgData name="이선영" userId="91632b05-5949-44db-840d-a7fdc9de9d00" providerId="ADAL" clId="{EA729F21-364D-4F8F-87D4-42DDD6AE3364}" dt="2021-05-03T23:32:27.623" v="581" actId="6549"/>
          <ac:spMkLst>
            <pc:docMk/>
            <pc:sldMk cId="3509119941" sldId="262"/>
            <ac:spMk id="15" creationId="{F9C48FFA-09FA-4B6E-8B73-55811F4B2793}"/>
          </ac:spMkLst>
        </pc:spChg>
        <pc:spChg chg="add mod">
          <ac:chgData name="이선영" userId="91632b05-5949-44db-840d-a7fdc9de9d00" providerId="ADAL" clId="{EA729F21-364D-4F8F-87D4-42DDD6AE3364}" dt="2021-05-03T23:32:34.538" v="587" actId="6549"/>
          <ac:spMkLst>
            <pc:docMk/>
            <pc:sldMk cId="3509119941" sldId="262"/>
            <ac:spMk id="16" creationId="{EB09F545-4C1E-4CAE-83CE-F6B78DC489A7}"/>
          </ac:spMkLst>
        </pc:spChg>
        <pc:spChg chg="add mod">
          <ac:chgData name="이선영" userId="91632b05-5949-44db-840d-a7fdc9de9d00" providerId="ADAL" clId="{EA729F21-364D-4F8F-87D4-42DDD6AE3364}" dt="2021-05-06T12:05:50.352" v="816" actId="1076"/>
          <ac:spMkLst>
            <pc:docMk/>
            <pc:sldMk cId="3509119941" sldId="262"/>
            <ac:spMk id="17" creationId="{14056A6B-4EB9-4CE5-AEA3-E270576EAFB2}"/>
          </ac:spMkLst>
        </pc:spChg>
        <pc:spChg chg="add mod">
          <ac:chgData name="이선영" userId="91632b05-5949-44db-840d-a7fdc9de9d00" providerId="ADAL" clId="{EA729F21-364D-4F8F-87D4-42DDD6AE3364}" dt="2021-05-06T12:05:50.352" v="816" actId="1076"/>
          <ac:spMkLst>
            <pc:docMk/>
            <pc:sldMk cId="3509119941" sldId="262"/>
            <ac:spMk id="18" creationId="{2E2F9428-3862-4DFF-9145-4A55158EEA6C}"/>
          </ac:spMkLst>
        </pc:spChg>
        <pc:graphicFrameChg chg="del mod">
          <ac:chgData name="이선영" userId="91632b05-5949-44db-840d-a7fdc9de9d00" providerId="ADAL" clId="{EA729F21-364D-4F8F-87D4-42DDD6AE3364}" dt="2021-05-03T23:28:23.070" v="441" actId="478"/>
          <ac:graphicFrameMkLst>
            <pc:docMk/>
            <pc:sldMk cId="3509119941" sldId="262"/>
            <ac:graphicFrameMk id="4" creationId="{796AABB8-3642-4296-B037-D4A042951275}"/>
          </ac:graphicFrameMkLst>
        </pc:graphicFrameChg>
        <pc:graphicFrameChg chg="del mod">
          <ac:chgData name="이선영" userId="91632b05-5949-44db-840d-a7fdc9de9d00" providerId="ADAL" clId="{EA729F21-364D-4F8F-87D4-42DDD6AE3364}" dt="2021-05-03T23:28:23.070" v="441" actId="478"/>
          <ac:graphicFrameMkLst>
            <pc:docMk/>
            <pc:sldMk cId="3509119941" sldId="262"/>
            <ac:graphicFrameMk id="5" creationId="{ABCA74F8-30A2-41EF-BF17-03D2057BC2FE}"/>
          </ac:graphicFrameMkLst>
        </pc:graphicFrameChg>
        <pc:graphicFrameChg chg="add mod">
          <ac:chgData name="이선영" userId="91632b05-5949-44db-840d-a7fdc9de9d00" providerId="ADAL" clId="{EA729F21-364D-4F8F-87D4-42DDD6AE3364}" dt="2021-05-03T23:32:04.120" v="564" actId="403"/>
          <ac:graphicFrameMkLst>
            <pc:docMk/>
            <pc:sldMk cId="3509119941" sldId="262"/>
            <ac:graphicFrameMk id="13" creationId="{796AABB8-3642-4296-B037-D4A042951275}"/>
          </ac:graphicFrameMkLst>
        </pc:graphicFrameChg>
        <pc:graphicFrameChg chg="add mod">
          <ac:chgData name="이선영" userId="91632b05-5949-44db-840d-a7fdc9de9d00" providerId="ADAL" clId="{EA729F21-364D-4F8F-87D4-42DDD6AE3364}" dt="2021-05-03T23:32:17.320" v="570" actId="403"/>
          <ac:graphicFrameMkLst>
            <pc:docMk/>
            <pc:sldMk cId="3509119941" sldId="262"/>
            <ac:graphicFrameMk id="14" creationId="{ABCA74F8-30A2-41EF-BF17-03D2057BC2FE}"/>
          </ac:graphicFrameMkLst>
        </pc:graphicFrameChg>
      </pc:sldChg>
      <pc:sldChg chg="modSp new mod">
        <pc:chgData name="이선영" userId="91632b05-5949-44db-840d-a7fdc9de9d00" providerId="ADAL" clId="{EA729F21-364D-4F8F-87D4-42DDD6AE3364}" dt="2021-05-06T12:04:58.353" v="800" actId="20577"/>
        <pc:sldMkLst>
          <pc:docMk/>
          <pc:sldMk cId="1726862765" sldId="263"/>
        </pc:sldMkLst>
        <pc:spChg chg="mod">
          <ac:chgData name="이선영" userId="91632b05-5949-44db-840d-a7fdc9de9d00" providerId="ADAL" clId="{EA729F21-364D-4F8F-87D4-42DDD6AE3364}" dt="2021-05-06T12:04:58.353" v="800" actId="20577"/>
          <ac:spMkLst>
            <pc:docMk/>
            <pc:sldMk cId="1726862765" sldId="263"/>
            <ac:spMk id="2" creationId="{CBE0D5CE-186B-4F01-847A-A0CEF1EC81DF}"/>
          </ac:spMkLst>
        </pc:spChg>
      </pc:sldChg>
      <pc:sldChg chg="new del">
        <pc:chgData name="이선영" userId="91632b05-5949-44db-840d-a7fdc9de9d00" providerId="ADAL" clId="{EA729F21-364D-4F8F-87D4-42DDD6AE3364}" dt="2021-05-03T23:33:23.920" v="626" actId="47"/>
        <pc:sldMkLst>
          <pc:docMk/>
          <pc:sldMk cId="1802170686" sldId="263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mysnu-my.sharepoint.com/personal/sy2376_seoul_ac_kr/Documents/EMS_&#50672;&#44396;/NEDIS_cancer_2021/210415_cancer_resul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https://mysnu-my.sharepoint.com/personal/sy2376_seoul_ac_kr/Documents/EMS_&#50672;&#44396;/NEDIS_cancer_2021/210415_cancer_result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mysnu-my.sharepoint.com/personal/sy2376_seoul_ac_kr/Documents/EMS_&#50672;&#44396;/NEDIS_cancer_2021/210415_cancer_resul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mysnu-my.sharepoint.com/personal/sy2376_seoul_ac_kr/Documents/EMS_&#50672;&#44396;/NEDIS_cancer_2021/210415_cancer_resul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mysnu-my.sharepoint.com/personal/sy2376_seoul_ac_kr/Documents/EMS_&#50672;&#44396;/NEDIS_cancer_2021/210415_cancer_resul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https://mysnu-my.sharepoint.com/personal/sy2376_seoul_ac_kr/Documents/EMS_&#50672;&#44396;/NEDIS_cancer_2021/210415_cancer_result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https://mysnu-my.sharepoint.com/personal/sy2376_seoul_ac_kr/Documents/EMS_&#50672;&#44396;/NEDIS_cancer_2021/210415_cancer_result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https://mysnu-my.sharepoint.com/personal/sy2376_seoul_ac_kr/Documents/EMS_&#50672;&#44396;/NEDIS_cancer_2021/210415_cancer_result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https://mysnu-my.sharepoint.com/personal/sy2376_seoul_ac_kr/Documents/EMS_&#50672;&#44396;/NEDIS_cancer_2021/210415_cancer_result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https://mysnu-my.sharepoint.com/personal/sy2376_seoul_ac_kr/Documents/EMS_&#50672;&#44396;/NEDIS_cancer_2021/210415_cancer_resul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16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7:$B$21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17:$E$21</c:f>
              <c:numCache>
                <c:formatCode>0.0</c:formatCode>
                <c:ptCount val="5"/>
                <c:pt idx="0">
                  <c:v>3.7054687006732787</c:v>
                </c:pt>
                <c:pt idx="1">
                  <c:v>4.1183283581937706</c:v>
                </c:pt>
                <c:pt idx="2">
                  <c:v>4.4777834792198057</c:v>
                </c:pt>
                <c:pt idx="3">
                  <c:v>4.6295502594648497</c:v>
                </c:pt>
                <c:pt idx="4">
                  <c:v>4.91843927461610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00-4C9A-9442-031A18BF90A6}"/>
            </c:ext>
          </c:extLst>
        </c:ser>
        <c:ser>
          <c:idx val="3"/>
          <c:order val="3"/>
          <c:tx>
            <c:strRef>
              <c:f>'Sup1'!$F$16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7:$B$21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17:$F$21</c:f>
              <c:numCache>
                <c:formatCode>0.0</c:formatCode>
                <c:ptCount val="5"/>
                <c:pt idx="0">
                  <c:v>10.319573319989459</c:v>
                </c:pt>
                <c:pt idx="1">
                  <c:v>10.79178110394149</c:v>
                </c:pt>
                <c:pt idx="2">
                  <c:v>11.653167990820505</c:v>
                </c:pt>
                <c:pt idx="3">
                  <c:v>12.068019223725004</c:v>
                </c:pt>
                <c:pt idx="4">
                  <c:v>12.505497086350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C00-4C9A-9442-031A18BF90A6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0512624"/>
        <c:axId val="420511448"/>
      </c:barChart>
      <c:lineChart>
        <c:grouping val="standard"/>
        <c:varyColors val="0"/>
        <c:ser>
          <c:idx val="0"/>
          <c:order val="0"/>
          <c:tx>
            <c:strRef>
              <c:f>'Sup1'!$C$16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7:$B$21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17:$C$21</c:f>
              <c:numCache>
                <c:formatCode>0.0</c:formatCode>
                <c:ptCount val="5"/>
                <c:pt idx="0">
                  <c:v>64.928133239233802</c:v>
                </c:pt>
                <c:pt idx="1">
                  <c:v>71.386966809393982</c:v>
                </c:pt>
                <c:pt idx="2">
                  <c:v>79.454305371247685</c:v>
                </c:pt>
                <c:pt idx="3">
                  <c:v>85.875720707673253</c:v>
                </c:pt>
                <c:pt idx="4">
                  <c:v>91.6232190733140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C00-4C9A-9442-031A18BF90A6}"/>
            </c:ext>
          </c:extLst>
        </c:ser>
        <c:ser>
          <c:idx val="1"/>
          <c:order val="1"/>
          <c:tx>
            <c:strRef>
              <c:f>'Sup1'!$D$16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7:$B$21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17:$D$21</c:f>
              <c:numCache>
                <c:formatCode>0.0</c:formatCode>
                <c:ptCount val="5"/>
                <c:pt idx="0">
                  <c:v>41.841571625875865</c:v>
                </c:pt>
                <c:pt idx="1">
                  <c:v>43.497764554737344</c:v>
                </c:pt>
                <c:pt idx="2">
                  <c:v>47.518378822200063</c:v>
                </c:pt>
                <c:pt idx="3">
                  <c:v>49.324690427578339</c:v>
                </c:pt>
                <c:pt idx="4">
                  <c:v>51.9737808813097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C00-4C9A-9442-031A18BF90A6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0512624"/>
        <c:axId val="420511448"/>
      </c:lineChart>
      <c:catAx>
        <c:axId val="42051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0511448"/>
        <c:crosses val="autoZero"/>
        <c:auto val="1"/>
        <c:lblAlgn val="ctr"/>
        <c:lblOffset val="100"/>
        <c:noMultiLvlLbl val="0"/>
      </c:catAx>
      <c:valAx>
        <c:axId val="420511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051262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282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83:$B$287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283:$E$287</c:f>
              <c:numCache>
                <c:formatCode>0.0</c:formatCode>
                <c:ptCount val="5"/>
                <c:pt idx="0">
                  <c:v>1.0206999999999999</c:v>
                </c:pt>
                <c:pt idx="1">
                  <c:v>1.1008</c:v>
                </c:pt>
                <c:pt idx="2">
                  <c:v>1.2354000000000001</c:v>
                </c:pt>
                <c:pt idx="3">
                  <c:v>1.2546999999999999</c:v>
                </c:pt>
                <c:pt idx="4">
                  <c:v>1.37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A7-4581-979B-1AA706E32984}"/>
            </c:ext>
          </c:extLst>
        </c:ser>
        <c:ser>
          <c:idx val="3"/>
          <c:order val="3"/>
          <c:tx>
            <c:strRef>
              <c:f>'Sup1'!$F$282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83:$B$287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283:$F$287</c:f>
              <c:numCache>
                <c:formatCode>0.0</c:formatCode>
                <c:ptCount val="5"/>
                <c:pt idx="0">
                  <c:v>3.6030000000000002</c:v>
                </c:pt>
                <c:pt idx="1">
                  <c:v>3.7048000000000001</c:v>
                </c:pt>
                <c:pt idx="2">
                  <c:v>4.0578000000000003</c:v>
                </c:pt>
                <c:pt idx="3">
                  <c:v>4.0454999999999997</c:v>
                </c:pt>
                <c:pt idx="4">
                  <c:v>4.1687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CA7-4581-979B-1AA706E3298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3425952"/>
        <c:axId val="423426344"/>
      </c:barChart>
      <c:lineChart>
        <c:grouping val="standard"/>
        <c:varyColors val="0"/>
        <c:ser>
          <c:idx val="0"/>
          <c:order val="0"/>
          <c:tx>
            <c:strRef>
              <c:f>'Sup1'!$C$282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Pt>
            <c:idx val="4"/>
            <c:marker>
              <c:symbol val="circle"/>
              <c:size val="7"/>
              <c:spPr>
                <a:solidFill>
                  <a:srgbClr val="002060"/>
                </a:solidFill>
                <a:ln w="9525">
                  <a:solidFill>
                    <a:srgbClr val="00206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BCA7-4581-979B-1AA706E3298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83:$B$287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283:$C$287</c:f>
              <c:numCache>
                <c:formatCode>0.0</c:formatCode>
                <c:ptCount val="5"/>
                <c:pt idx="0">
                  <c:v>29.221800000000002</c:v>
                </c:pt>
                <c:pt idx="1">
                  <c:v>31.548500000000001</c:v>
                </c:pt>
                <c:pt idx="2">
                  <c:v>35.406300000000002</c:v>
                </c:pt>
                <c:pt idx="3">
                  <c:v>38.356400000000001</c:v>
                </c:pt>
                <c:pt idx="4">
                  <c:v>42.5476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CA7-4581-979B-1AA706E32984}"/>
            </c:ext>
          </c:extLst>
        </c:ser>
        <c:ser>
          <c:idx val="1"/>
          <c:order val="1"/>
          <c:tx>
            <c:strRef>
              <c:f>'Sup1'!$D$282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83:$B$287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283:$D$287</c:f>
              <c:numCache>
                <c:formatCode>0.0</c:formatCode>
                <c:ptCount val="5"/>
                <c:pt idx="0">
                  <c:v>17.025400000000001</c:v>
                </c:pt>
                <c:pt idx="1">
                  <c:v>17.942699999999999</c:v>
                </c:pt>
                <c:pt idx="2">
                  <c:v>19.697099999999999</c:v>
                </c:pt>
                <c:pt idx="3">
                  <c:v>20.556000000000001</c:v>
                </c:pt>
                <c:pt idx="4">
                  <c:v>22.3694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CA7-4581-979B-1AA706E32984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3425952"/>
        <c:axId val="423426344"/>
      </c:lineChart>
      <c:catAx>
        <c:axId val="423425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426344"/>
        <c:crosses val="autoZero"/>
        <c:auto val="1"/>
        <c:lblAlgn val="ctr"/>
        <c:lblOffset val="100"/>
        <c:noMultiLvlLbl val="0"/>
      </c:catAx>
      <c:valAx>
        <c:axId val="423426344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425952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25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6:$B$30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26:$E$30</c:f>
              <c:numCache>
                <c:formatCode>0.0</c:formatCode>
                <c:ptCount val="5"/>
                <c:pt idx="0">
                  <c:v>4.6662999999999997</c:v>
                </c:pt>
                <c:pt idx="1">
                  <c:v>4.9858000000000002</c:v>
                </c:pt>
                <c:pt idx="2">
                  <c:v>5.1768000000000001</c:v>
                </c:pt>
                <c:pt idx="3">
                  <c:v>5.1017000000000001</c:v>
                </c:pt>
                <c:pt idx="4">
                  <c:v>5.1632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5F-409B-97D1-A84771C00F6D}"/>
            </c:ext>
          </c:extLst>
        </c:ser>
        <c:ser>
          <c:idx val="3"/>
          <c:order val="3"/>
          <c:tx>
            <c:strRef>
              <c:f>'Sup1'!$F$25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6:$B$30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26:$F$30</c:f>
              <c:numCache>
                <c:formatCode>0.0</c:formatCode>
                <c:ptCount val="5"/>
                <c:pt idx="0">
                  <c:v>12.930400000000001</c:v>
                </c:pt>
                <c:pt idx="1">
                  <c:v>13.038600000000001</c:v>
                </c:pt>
                <c:pt idx="2">
                  <c:v>13.4292</c:v>
                </c:pt>
                <c:pt idx="3">
                  <c:v>13.2721</c:v>
                </c:pt>
                <c:pt idx="4">
                  <c:v>13.11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A5F-409B-97D1-A84771C00F6D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0513016"/>
        <c:axId val="420514976"/>
      </c:barChart>
      <c:lineChart>
        <c:grouping val="standard"/>
        <c:varyColors val="0"/>
        <c:ser>
          <c:idx val="0"/>
          <c:order val="0"/>
          <c:tx>
            <c:strRef>
              <c:f>'Sup1'!$C$25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6:$B$30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26:$C$30</c:f>
              <c:numCache>
                <c:formatCode>0.0</c:formatCode>
                <c:ptCount val="5"/>
                <c:pt idx="0">
                  <c:v>79.853200000000001</c:v>
                </c:pt>
                <c:pt idx="1">
                  <c:v>84.637600000000006</c:v>
                </c:pt>
                <c:pt idx="2">
                  <c:v>90.450199999999995</c:v>
                </c:pt>
                <c:pt idx="3">
                  <c:v>93.639600000000002</c:v>
                </c:pt>
                <c:pt idx="4">
                  <c:v>95.6885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A5F-409B-97D1-A84771C00F6D}"/>
            </c:ext>
          </c:extLst>
        </c:ser>
        <c:ser>
          <c:idx val="1"/>
          <c:order val="1"/>
          <c:tx>
            <c:strRef>
              <c:f>'Sup1'!$D$25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6:$B$30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26:$D$30</c:f>
              <c:numCache>
                <c:formatCode>0.0</c:formatCode>
                <c:ptCount val="5"/>
                <c:pt idx="0">
                  <c:v>51.910899999999998</c:v>
                </c:pt>
                <c:pt idx="1">
                  <c:v>51.972499999999997</c:v>
                </c:pt>
                <c:pt idx="2">
                  <c:v>54.413600000000002</c:v>
                </c:pt>
                <c:pt idx="3">
                  <c:v>54.029800000000002</c:v>
                </c:pt>
                <c:pt idx="4">
                  <c:v>54.4112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A5F-409B-97D1-A84771C00F6D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0513016"/>
        <c:axId val="420514976"/>
      </c:lineChart>
      <c:catAx>
        <c:axId val="420513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0514976"/>
        <c:crosses val="autoZero"/>
        <c:auto val="1"/>
        <c:lblAlgn val="ctr"/>
        <c:lblOffset val="100"/>
        <c:noMultiLvlLbl val="0"/>
      </c:catAx>
      <c:valAx>
        <c:axId val="42051497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051301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16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81:$B$85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81:$E$85</c:f>
              <c:numCache>
                <c:formatCode>0.0</c:formatCode>
                <c:ptCount val="5"/>
                <c:pt idx="0">
                  <c:v>4.7123042109727447</c:v>
                </c:pt>
                <c:pt idx="1">
                  <c:v>4.9478633814118984</c:v>
                </c:pt>
                <c:pt idx="2">
                  <c:v>5.2722289352104159</c:v>
                </c:pt>
                <c:pt idx="3">
                  <c:v>5.0096607018209109</c:v>
                </c:pt>
                <c:pt idx="4">
                  <c:v>5.57098468332755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35-4E71-9F2D-59FB8A97FAC1}"/>
            </c:ext>
          </c:extLst>
        </c:ser>
        <c:ser>
          <c:idx val="3"/>
          <c:order val="3"/>
          <c:tx>
            <c:strRef>
              <c:f>'Sup1'!$F$16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81:$B$85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81:$F$85</c:f>
              <c:numCache>
                <c:formatCode>0.0</c:formatCode>
                <c:ptCount val="5"/>
                <c:pt idx="0">
                  <c:v>8.2273966065796529</c:v>
                </c:pt>
                <c:pt idx="1">
                  <c:v>8.5496888006207978</c:v>
                </c:pt>
                <c:pt idx="2">
                  <c:v>8.5866475697854945</c:v>
                </c:pt>
                <c:pt idx="3">
                  <c:v>8.5671045854096892</c:v>
                </c:pt>
                <c:pt idx="4">
                  <c:v>8.76943113438484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35-4E71-9F2D-59FB8A97FAC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0513408"/>
        <c:axId val="420513800"/>
      </c:barChart>
      <c:lineChart>
        <c:grouping val="standard"/>
        <c:varyColors val="0"/>
        <c:ser>
          <c:idx val="0"/>
          <c:order val="0"/>
          <c:tx>
            <c:strRef>
              <c:f>'Sup1'!$C$16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Pt>
            <c:idx val="4"/>
            <c:marker>
              <c:symbol val="circle"/>
              <c:size val="7"/>
              <c:spPr>
                <a:solidFill>
                  <a:srgbClr val="002060"/>
                </a:solidFill>
                <a:ln w="9525">
                  <a:solidFill>
                    <a:srgbClr val="00206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535-4E71-9F2D-59FB8A97FAC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81:$B$85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81:$C$85</c:f>
              <c:numCache>
                <c:formatCode>0.0</c:formatCode>
                <c:ptCount val="5"/>
                <c:pt idx="0">
                  <c:v>63.646527804096266</c:v>
                </c:pt>
                <c:pt idx="1">
                  <c:v>65.607611954237498</c:v>
                </c:pt>
                <c:pt idx="2">
                  <c:v>69.632070642636492</c:v>
                </c:pt>
                <c:pt idx="3">
                  <c:v>73.46267815934813</c:v>
                </c:pt>
                <c:pt idx="4">
                  <c:v>77.6314767724952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535-4E71-9F2D-59FB8A97FAC1}"/>
            </c:ext>
          </c:extLst>
        </c:ser>
        <c:ser>
          <c:idx val="1"/>
          <c:order val="1"/>
          <c:tx>
            <c:strRef>
              <c:f>'Sup1'!$D$16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81:$B$85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81:$D$85</c:f>
              <c:numCache>
                <c:formatCode>0.0</c:formatCode>
                <c:ptCount val="5"/>
                <c:pt idx="0">
                  <c:v>38.353956222752757</c:v>
                </c:pt>
                <c:pt idx="1">
                  <c:v>38.334691615415082</c:v>
                </c:pt>
                <c:pt idx="2">
                  <c:v>40.120471504744501</c:v>
                </c:pt>
                <c:pt idx="3">
                  <c:v>40.917427156390175</c:v>
                </c:pt>
                <c:pt idx="4">
                  <c:v>42.3316920063197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535-4E71-9F2D-59FB8A97FAC1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0513408"/>
        <c:axId val="420513800"/>
      </c:lineChart>
      <c:catAx>
        <c:axId val="420513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0513800"/>
        <c:crosses val="autoZero"/>
        <c:auto val="1"/>
        <c:lblAlgn val="ctr"/>
        <c:lblOffset val="100"/>
        <c:noMultiLvlLbl val="0"/>
      </c:catAx>
      <c:valAx>
        <c:axId val="4205138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0513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25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90:$B$94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90:$E$94</c:f>
              <c:numCache>
                <c:formatCode>0.0</c:formatCode>
                <c:ptCount val="5"/>
                <c:pt idx="0">
                  <c:v>5.5819000000000001</c:v>
                </c:pt>
                <c:pt idx="1">
                  <c:v>5.7016999999999998</c:v>
                </c:pt>
                <c:pt idx="2">
                  <c:v>5.8864999999999998</c:v>
                </c:pt>
                <c:pt idx="3">
                  <c:v>5.3937999999999997</c:v>
                </c:pt>
                <c:pt idx="4">
                  <c:v>5.7838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91-441C-B60A-5F523D4CFD17}"/>
            </c:ext>
          </c:extLst>
        </c:ser>
        <c:ser>
          <c:idx val="3"/>
          <c:order val="3"/>
          <c:tx>
            <c:strRef>
              <c:f>'Sup1'!$F$25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90:$B$94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90:$F$94</c:f>
              <c:numCache>
                <c:formatCode>0.0</c:formatCode>
                <c:ptCount val="5"/>
                <c:pt idx="0">
                  <c:v>9.7807999999999993</c:v>
                </c:pt>
                <c:pt idx="1">
                  <c:v>9.8569999999999993</c:v>
                </c:pt>
                <c:pt idx="2">
                  <c:v>9.5973000000000006</c:v>
                </c:pt>
                <c:pt idx="3">
                  <c:v>9.2418999999999993</c:v>
                </c:pt>
                <c:pt idx="4">
                  <c:v>9.112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B91-441C-B60A-5F523D4CFD17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0514584"/>
        <c:axId val="420518504"/>
      </c:barChart>
      <c:lineChart>
        <c:grouping val="standard"/>
        <c:varyColors val="0"/>
        <c:ser>
          <c:idx val="0"/>
          <c:order val="0"/>
          <c:tx>
            <c:strRef>
              <c:f>'Sup1'!$C$25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90:$B$94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90:$C$94</c:f>
              <c:numCache>
                <c:formatCode>0.0</c:formatCode>
                <c:ptCount val="5"/>
                <c:pt idx="0">
                  <c:v>75.187600000000003</c:v>
                </c:pt>
                <c:pt idx="1">
                  <c:v>74.992900000000006</c:v>
                </c:pt>
                <c:pt idx="2">
                  <c:v>77.200299999999999</c:v>
                </c:pt>
                <c:pt idx="3">
                  <c:v>78.858099999999993</c:v>
                </c:pt>
                <c:pt idx="4">
                  <c:v>80.4979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B91-441C-B60A-5F523D4CFD17}"/>
            </c:ext>
          </c:extLst>
        </c:ser>
        <c:ser>
          <c:idx val="1"/>
          <c:order val="1"/>
          <c:tx>
            <c:strRef>
              <c:f>'Sup1'!$D$25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90:$B$94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90:$D$94</c:f>
              <c:numCache>
                <c:formatCode>0.0</c:formatCode>
                <c:ptCount val="5"/>
                <c:pt idx="0">
                  <c:v>45.650300000000001</c:v>
                </c:pt>
                <c:pt idx="1">
                  <c:v>44.202500000000001</c:v>
                </c:pt>
                <c:pt idx="2">
                  <c:v>44.771000000000001</c:v>
                </c:pt>
                <c:pt idx="3">
                  <c:v>44.069400000000002</c:v>
                </c:pt>
                <c:pt idx="4">
                  <c:v>43.9789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B91-441C-B60A-5F523D4CFD17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0514584"/>
        <c:axId val="420518504"/>
      </c:lineChart>
      <c:catAx>
        <c:axId val="420514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0518504"/>
        <c:crosses val="autoZero"/>
        <c:auto val="1"/>
        <c:lblAlgn val="ctr"/>
        <c:lblOffset val="100"/>
        <c:noMultiLvlLbl val="0"/>
      </c:catAx>
      <c:valAx>
        <c:axId val="4205185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051458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144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45:$B$149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145:$E$149</c:f>
              <c:numCache>
                <c:formatCode>0.0</c:formatCode>
                <c:ptCount val="5"/>
                <c:pt idx="0">
                  <c:v>2.7359233944589776</c:v>
                </c:pt>
                <c:pt idx="1">
                  <c:v>3.151841798123594</c:v>
                </c:pt>
                <c:pt idx="2">
                  <c:v>3.5720766203017629</c:v>
                </c:pt>
                <c:pt idx="3">
                  <c:v>3.4677768048791444</c:v>
                </c:pt>
                <c:pt idx="4">
                  <c:v>3.800346544465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C2-4674-A7C6-A7A86B3BFC02}"/>
            </c:ext>
          </c:extLst>
        </c:ser>
        <c:ser>
          <c:idx val="3"/>
          <c:order val="3"/>
          <c:tx>
            <c:strRef>
              <c:f>'Sup1'!$F$144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45:$B$149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145:$F$149</c:f>
              <c:numCache>
                <c:formatCode>0.0</c:formatCode>
                <c:ptCount val="5"/>
                <c:pt idx="0">
                  <c:v>4.1470632227344479</c:v>
                </c:pt>
                <c:pt idx="1">
                  <c:v>4.2337589392547841</c:v>
                </c:pt>
                <c:pt idx="2">
                  <c:v>4.6436996063922917</c:v>
                </c:pt>
                <c:pt idx="3">
                  <c:v>4.6685359458603433</c:v>
                </c:pt>
                <c:pt idx="4">
                  <c:v>5.01778200847964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FC2-4674-A7C6-A7A86B3BFC0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0518112"/>
        <c:axId val="240256048"/>
      </c:barChart>
      <c:lineChart>
        <c:grouping val="standard"/>
        <c:varyColors val="0"/>
        <c:ser>
          <c:idx val="0"/>
          <c:order val="0"/>
          <c:tx>
            <c:strRef>
              <c:f>'Sup1'!$C$144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Pt>
            <c:idx val="4"/>
            <c:marker>
              <c:symbol val="circle"/>
              <c:size val="7"/>
              <c:spPr>
                <a:solidFill>
                  <a:srgbClr val="002060"/>
                </a:solidFill>
                <a:ln w="9525">
                  <a:solidFill>
                    <a:srgbClr val="00206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FC2-4674-A7C6-A7A86B3BFC0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45:$B$149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145:$C$149</c:f>
              <c:numCache>
                <c:formatCode>0.0</c:formatCode>
                <c:ptCount val="5"/>
                <c:pt idx="0">
                  <c:v>52.245538565637013</c:v>
                </c:pt>
                <c:pt idx="1">
                  <c:v>56.920971616764646</c:v>
                </c:pt>
                <c:pt idx="2">
                  <c:v>62.677256982453329</c:v>
                </c:pt>
                <c:pt idx="3">
                  <c:v>66.123622695396477</c:v>
                </c:pt>
                <c:pt idx="4">
                  <c:v>69.9450762268971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FC2-4674-A7C6-A7A86B3BFC02}"/>
            </c:ext>
          </c:extLst>
        </c:ser>
        <c:ser>
          <c:idx val="1"/>
          <c:order val="1"/>
          <c:tx>
            <c:strRef>
              <c:f>'Sup1'!$D$144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45:$B$149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145:$D$149</c:f>
              <c:numCache>
                <c:formatCode>0.0</c:formatCode>
                <c:ptCount val="5"/>
                <c:pt idx="0">
                  <c:v>29.420008380875235</c:v>
                </c:pt>
                <c:pt idx="1">
                  <c:v>31.089955315941666</c:v>
                </c:pt>
                <c:pt idx="2">
                  <c:v>33.532625278778134</c:v>
                </c:pt>
                <c:pt idx="3">
                  <c:v>34.679717333111221</c:v>
                </c:pt>
                <c:pt idx="4">
                  <c:v>36.507480746477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FC2-4674-A7C6-A7A86B3BFC0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0518112"/>
        <c:axId val="240256048"/>
      </c:lineChart>
      <c:catAx>
        <c:axId val="420518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240256048"/>
        <c:crosses val="autoZero"/>
        <c:auto val="1"/>
        <c:lblAlgn val="ctr"/>
        <c:lblOffset val="100"/>
        <c:noMultiLvlLbl val="0"/>
      </c:catAx>
      <c:valAx>
        <c:axId val="240256048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051811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153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54:$B$158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154:$E$158</c:f>
              <c:numCache>
                <c:formatCode>0.0</c:formatCode>
                <c:ptCount val="5"/>
                <c:pt idx="0">
                  <c:v>3.4658000000000002</c:v>
                </c:pt>
                <c:pt idx="1">
                  <c:v>3.8104</c:v>
                </c:pt>
                <c:pt idx="2">
                  <c:v>4.1124999999999998</c:v>
                </c:pt>
                <c:pt idx="3">
                  <c:v>3.8146</c:v>
                </c:pt>
                <c:pt idx="4">
                  <c:v>3.986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AF-46B4-9C2B-D3ACFFE1F295}"/>
            </c:ext>
          </c:extLst>
        </c:ser>
        <c:ser>
          <c:idx val="3"/>
          <c:order val="3"/>
          <c:tx>
            <c:strRef>
              <c:f>'Sup1'!$F$153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54:$B$158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154:$F$158</c:f>
              <c:numCache>
                <c:formatCode>0.0</c:formatCode>
                <c:ptCount val="5"/>
                <c:pt idx="0">
                  <c:v>5.0987999999999998</c:v>
                </c:pt>
                <c:pt idx="1">
                  <c:v>5.0301</c:v>
                </c:pt>
                <c:pt idx="2">
                  <c:v>5.3082000000000003</c:v>
                </c:pt>
                <c:pt idx="3">
                  <c:v>5.0937999999999999</c:v>
                </c:pt>
                <c:pt idx="4">
                  <c:v>5.2427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AF-46B4-9C2B-D3ACFFE1F295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3054280"/>
        <c:axId val="423054672"/>
      </c:barChart>
      <c:lineChart>
        <c:grouping val="standard"/>
        <c:varyColors val="0"/>
        <c:ser>
          <c:idx val="0"/>
          <c:order val="0"/>
          <c:tx>
            <c:strRef>
              <c:f>'Sup1'!$C$153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Pt>
            <c:idx val="4"/>
            <c:marker>
              <c:symbol val="circle"/>
              <c:size val="7"/>
              <c:spPr>
                <a:solidFill>
                  <a:srgbClr val="002060"/>
                </a:solidFill>
                <a:ln w="9525">
                  <a:solidFill>
                    <a:srgbClr val="00206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97AF-46B4-9C2B-D3ACFFE1F295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54:$B$158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154:$C$158</c:f>
              <c:numCache>
                <c:formatCode>0.0</c:formatCode>
                <c:ptCount val="5"/>
                <c:pt idx="0">
                  <c:v>62.3232</c:v>
                </c:pt>
                <c:pt idx="1">
                  <c:v>65.694000000000003</c:v>
                </c:pt>
                <c:pt idx="2">
                  <c:v>69.694800000000001</c:v>
                </c:pt>
                <c:pt idx="3">
                  <c:v>71.055599999999998</c:v>
                </c:pt>
                <c:pt idx="4">
                  <c:v>72.5785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7AF-46B4-9C2B-D3ACFFE1F295}"/>
            </c:ext>
          </c:extLst>
        </c:ser>
        <c:ser>
          <c:idx val="1"/>
          <c:order val="1"/>
          <c:tx>
            <c:strRef>
              <c:f>'Sup1'!$D$153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154:$B$158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154:$D$158</c:f>
              <c:numCache>
                <c:formatCode>0.0</c:formatCode>
                <c:ptCount val="5"/>
                <c:pt idx="0">
                  <c:v>35.703400000000002</c:v>
                </c:pt>
                <c:pt idx="1">
                  <c:v>36.436100000000003</c:v>
                </c:pt>
                <c:pt idx="2">
                  <c:v>37.8523</c:v>
                </c:pt>
                <c:pt idx="3">
                  <c:v>37.608499999999999</c:v>
                </c:pt>
                <c:pt idx="4">
                  <c:v>38.0193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97AF-46B4-9C2B-D3ACFFE1F295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3054280"/>
        <c:axId val="423054672"/>
      </c:lineChart>
      <c:catAx>
        <c:axId val="423054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054672"/>
        <c:crosses val="autoZero"/>
        <c:auto val="1"/>
        <c:lblAlgn val="ctr"/>
        <c:lblOffset val="100"/>
        <c:noMultiLvlLbl val="0"/>
      </c:catAx>
      <c:valAx>
        <c:axId val="42305467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054280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209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10:$B$214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210:$E$214</c:f>
              <c:numCache>
                <c:formatCode>0.0</c:formatCode>
                <c:ptCount val="5"/>
                <c:pt idx="0">
                  <c:v>2.4748919658628199</c:v>
                </c:pt>
                <c:pt idx="1">
                  <c:v>2.6685985180885052</c:v>
                </c:pt>
                <c:pt idx="2">
                  <c:v>2.7366401211273614</c:v>
                </c:pt>
                <c:pt idx="3">
                  <c:v>2.5262724784279769</c:v>
                </c:pt>
                <c:pt idx="4">
                  <c:v>2.84587714067886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A2-4CD0-B895-0AF2F0BE549F}"/>
            </c:ext>
          </c:extLst>
        </c:ser>
        <c:ser>
          <c:idx val="3"/>
          <c:order val="3"/>
          <c:tx>
            <c:strRef>
              <c:f>'Sup1'!$F$209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10:$B$214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210:$F$214</c:f>
              <c:numCache>
                <c:formatCode>0.0</c:formatCode>
                <c:ptCount val="5"/>
                <c:pt idx="0">
                  <c:v>4.4493101400563146</c:v>
                </c:pt>
                <c:pt idx="1">
                  <c:v>4.3609282234745441</c:v>
                </c:pt>
                <c:pt idx="2">
                  <c:v>4.4543600259719245</c:v>
                </c:pt>
                <c:pt idx="3">
                  <c:v>4.506745347319046</c:v>
                </c:pt>
                <c:pt idx="4">
                  <c:v>4.47431881734384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5A2-4CD0-B895-0AF2F0BE549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3055456"/>
        <c:axId val="423048400"/>
      </c:barChart>
      <c:lineChart>
        <c:grouping val="standard"/>
        <c:varyColors val="0"/>
        <c:ser>
          <c:idx val="0"/>
          <c:order val="0"/>
          <c:tx>
            <c:strRef>
              <c:f>'Sup1'!$C$209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Pt>
            <c:idx val="4"/>
            <c:marker>
              <c:symbol val="circle"/>
              <c:size val="7"/>
              <c:spPr>
                <a:solidFill>
                  <a:srgbClr val="002060"/>
                </a:solidFill>
                <a:ln w="9525">
                  <a:solidFill>
                    <a:srgbClr val="00206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B5A2-4CD0-B895-0AF2F0BE549F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10:$B$214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210:$C$214</c:f>
              <c:numCache>
                <c:formatCode>0.0</c:formatCode>
                <c:ptCount val="5"/>
                <c:pt idx="0">
                  <c:v>44.997500476873022</c:v>
                </c:pt>
                <c:pt idx="1">
                  <c:v>45.878764845436542</c:v>
                </c:pt>
                <c:pt idx="2">
                  <c:v>49.148260777365074</c:v>
                </c:pt>
                <c:pt idx="3">
                  <c:v>49.552756692991984</c:v>
                </c:pt>
                <c:pt idx="4">
                  <c:v>51.2199448419923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5A2-4CD0-B895-0AF2F0BE549F}"/>
            </c:ext>
          </c:extLst>
        </c:ser>
        <c:ser>
          <c:idx val="1"/>
          <c:order val="1"/>
          <c:tx>
            <c:strRef>
              <c:f>'Sup1'!$D$209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10:$B$214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210:$D$214</c:f>
              <c:numCache>
                <c:formatCode>0.0</c:formatCode>
                <c:ptCount val="5"/>
                <c:pt idx="0">
                  <c:v>26.925489991809698</c:v>
                </c:pt>
                <c:pt idx="1">
                  <c:v>26.709462587202548</c:v>
                </c:pt>
                <c:pt idx="2">
                  <c:v>28.14718298620296</c:v>
                </c:pt>
                <c:pt idx="3">
                  <c:v>27.500503183381095</c:v>
                </c:pt>
                <c:pt idx="4">
                  <c:v>28.3321581185312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5A2-4CD0-B895-0AF2F0BE549F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3055456"/>
        <c:axId val="423048400"/>
      </c:lineChart>
      <c:catAx>
        <c:axId val="42305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048400"/>
        <c:crosses val="autoZero"/>
        <c:auto val="1"/>
        <c:lblAlgn val="ctr"/>
        <c:lblOffset val="100"/>
        <c:noMultiLvlLbl val="0"/>
      </c:catAx>
      <c:valAx>
        <c:axId val="423048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0554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218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19:$B$223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219:$E$223</c:f>
              <c:numCache>
                <c:formatCode>0.0</c:formatCode>
                <c:ptCount val="5"/>
                <c:pt idx="0">
                  <c:v>3.0983000000000001</c:v>
                </c:pt>
                <c:pt idx="1">
                  <c:v>3.2094999999999998</c:v>
                </c:pt>
                <c:pt idx="2">
                  <c:v>3.1496</c:v>
                </c:pt>
                <c:pt idx="3">
                  <c:v>2.7711999999999999</c:v>
                </c:pt>
                <c:pt idx="4">
                  <c:v>2.98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53-492A-ABCB-143532A4BAD6}"/>
            </c:ext>
          </c:extLst>
        </c:ser>
        <c:ser>
          <c:idx val="3"/>
          <c:order val="3"/>
          <c:tx>
            <c:strRef>
              <c:f>'Sup1'!$F$218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19:$B$223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219:$F$223</c:f>
              <c:numCache>
                <c:formatCode>0.0</c:formatCode>
                <c:ptCount val="5"/>
                <c:pt idx="0">
                  <c:v>5.3872999999999998</c:v>
                </c:pt>
                <c:pt idx="1">
                  <c:v>5.1138000000000003</c:v>
                </c:pt>
                <c:pt idx="2">
                  <c:v>5.0232000000000001</c:v>
                </c:pt>
                <c:pt idx="3">
                  <c:v>4.8933</c:v>
                </c:pt>
                <c:pt idx="4">
                  <c:v>4.6635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53-492A-ABCB-143532A4BAD6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3051928"/>
        <c:axId val="423049968"/>
      </c:barChart>
      <c:lineChart>
        <c:grouping val="standard"/>
        <c:varyColors val="0"/>
        <c:ser>
          <c:idx val="0"/>
          <c:order val="0"/>
          <c:tx>
            <c:strRef>
              <c:f>'Sup1'!$C$218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Pt>
            <c:idx val="4"/>
            <c:marker>
              <c:symbol val="circle"/>
              <c:size val="7"/>
              <c:spPr>
                <a:solidFill>
                  <a:srgbClr val="002060"/>
                </a:solidFill>
                <a:ln w="9525">
                  <a:solidFill>
                    <a:srgbClr val="00206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D53-492A-ABCB-143532A4BAD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19:$B$223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219:$C$223</c:f>
              <c:numCache>
                <c:formatCode>0.0</c:formatCode>
                <c:ptCount val="5"/>
                <c:pt idx="0">
                  <c:v>53.349899999999998</c:v>
                </c:pt>
                <c:pt idx="1">
                  <c:v>52.792499999999997</c:v>
                </c:pt>
                <c:pt idx="2">
                  <c:v>54.780999999999999</c:v>
                </c:pt>
                <c:pt idx="3">
                  <c:v>53.244399999999999</c:v>
                </c:pt>
                <c:pt idx="4">
                  <c:v>53.1146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D53-492A-ABCB-143532A4BAD6}"/>
            </c:ext>
          </c:extLst>
        </c:ser>
        <c:ser>
          <c:idx val="1"/>
          <c:order val="1"/>
          <c:tx>
            <c:strRef>
              <c:f>'Sup1'!$D$218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19:$B$223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219:$D$223</c:f>
              <c:numCache>
                <c:formatCode>0.0</c:formatCode>
                <c:ptCount val="5"/>
                <c:pt idx="0">
                  <c:v>32.376399999999997</c:v>
                </c:pt>
                <c:pt idx="1">
                  <c:v>31.179600000000001</c:v>
                </c:pt>
                <c:pt idx="2">
                  <c:v>31.630800000000001</c:v>
                </c:pt>
                <c:pt idx="3">
                  <c:v>29.738900000000001</c:v>
                </c:pt>
                <c:pt idx="4">
                  <c:v>29.4749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D53-492A-ABCB-143532A4BAD6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3051928"/>
        <c:axId val="423049968"/>
      </c:lineChart>
      <c:catAx>
        <c:axId val="423051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049968"/>
        <c:crosses val="autoZero"/>
        <c:auto val="1"/>
        <c:lblAlgn val="ctr"/>
        <c:lblOffset val="100"/>
        <c:noMultiLvlLbl val="0"/>
      </c:catAx>
      <c:valAx>
        <c:axId val="423049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0519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'Sup1'!$E$273</c:f>
              <c:strCache>
                <c:ptCount val="1"/>
                <c:pt idx="0">
                  <c:v>ICU admission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74:$B$278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E$274:$E$278</c:f>
              <c:numCache>
                <c:formatCode>0.0</c:formatCode>
                <c:ptCount val="5"/>
                <c:pt idx="0">
                  <c:v>0.82627241683445463</c:v>
                </c:pt>
                <c:pt idx="1">
                  <c:v>0.92148819796164649</c:v>
                </c:pt>
                <c:pt idx="2">
                  <c:v>1.0872386215891157</c:v>
                </c:pt>
                <c:pt idx="3">
                  <c:v>1.1481284643472829</c:v>
                </c:pt>
                <c:pt idx="4">
                  <c:v>1.31677819787742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0F-4264-872A-96DD28658FDA}"/>
            </c:ext>
          </c:extLst>
        </c:ser>
        <c:ser>
          <c:idx val="3"/>
          <c:order val="3"/>
          <c:tx>
            <c:strRef>
              <c:f>'Sup1'!$F$273</c:f>
              <c:strCache>
                <c:ptCount val="1"/>
                <c:pt idx="0">
                  <c:v>Hospital dea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74:$B$278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F$274:$F$278</c:f>
              <c:numCache>
                <c:formatCode>0.0</c:formatCode>
                <c:ptCount val="5"/>
                <c:pt idx="0">
                  <c:v>2.9400381957672517</c:v>
                </c:pt>
                <c:pt idx="1">
                  <c:v>3.1401030949648465</c:v>
                </c:pt>
                <c:pt idx="2">
                  <c:v>3.5915961646749968</c:v>
                </c:pt>
                <c:pt idx="3">
                  <c:v>3.7094880605312039</c:v>
                </c:pt>
                <c:pt idx="4">
                  <c:v>3.99513621870797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E0F-4264-872A-96DD28658FD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423051144"/>
        <c:axId val="423051536"/>
      </c:barChart>
      <c:lineChart>
        <c:grouping val="standard"/>
        <c:varyColors val="0"/>
        <c:ser>
          <c:idx val="0"/>
          <c:order val="0"/>
          <c:tx>
            <c:strRef>
              <c:f>'Sup1'!$C$273</c:f>
              <c:strCache>
                <c:ptCount val="1"/>
                <c:pt idx="0">
                  <c:v>ED visits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dPt>
            <c:idx val="4"/>
            <c:marker>
              <c:symbol val="circle"/>
              <c:size val="7"/>
              <c:spPr>
                <a:solidFill>
                  <a:srgbClr val="002060"/>
                </a:solidFill>
                <a:ln w="9525">
                  <a:solidFill>
                    <a:srgbClr val="00206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E0F-4264-872A-96DD28658FD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74:$B$278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C$274:$C$278</c:f>
              <c:numCache>
                <c:formatCode>0.0</c:formatCode>
                <c:ptCount val="5"/>
                <c:pt idx="0">
                  <c:v>24.562468638202375</c:v>
                </c:pt>
                <c:pt idx="1">
                  <c:v>27.347265458827803</c:v>
                </c:pt>
                <c:pt idx="2">
                  <c:v>31.742683059752604</c:v>
                </c:pt>
                <c:pt idx="3">
                  <c:v>35.625120228201936</c:v>
                </c:pt>
                <c:pt idx="4">
                  <c:v>40.9954348410180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E0F-4264-872A-96DD28658FDA}"/>
            </c:ext>
          </c:extLst>
        </c:ser>
        <c:ser>
          <c:idx val="1"/>
          <c:order val="1"/>
          <c:tx>
            <c:strRef>
              <c:f>'Sup1'!$D$273</c:f>
              <c:strCache>
                <c:ptCount val="1"/>
                <c:pt idx="0">
                  <c:v>Admission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Georgia" panose="02040502050405020303" pitchFamily="18" charset="0"/>
                    <a:ea typeface="+mn-ea"/>
                    <a:cs typeface="+mn-cs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Sup1'!$B$274:$B$278</c:f>
              <c:numCache>
                <c:formatCode>General</c:formatCode>
                <c:ptCount val="5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</c:numCache>
            </c:numRef>
          </c:cat>
          <c:val>
            <c:numRef>
              <c:f>'Sup1'!$D$274:$D$278</c:f>
              <c:numCache>
                <c:formatCode>0.0</c:formatCode>
                <c:ptCount val="5"/>
                <c:pt idx="0">
                  <c:v>14.119248852035787</c:v>
                </c:pt>
                <c:pt idx="1">
                  <c:v>15.317051171638495</c:v>
                </c:pt>
                <c:pt idx="2">
                  <c:v>17.522694983851871</c:v>
                </c:pt>
                <c:pt idx="3">
                  <c:v>18.991877127564646</c:v>
                </c:pt>
                <c:pt idx="4">
                  <c:v>21.4891968624019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E0F-4264-872A-96DD28658FDA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23051144"/>
        <c:axId val="423051536"/>
      </c:lineChart>
      <c:catAx>
        <c:axId val="423051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051536"/>
        <c:crosses val="autoZero"/>
        <c:auto val="1"/>
        <c:lblAlgn val="ctr"/>
        <c:lblOffset val="100"/>
        <c:noMultiLvlLbl val="0"/>
      </c:catAx>
      <c:valAx>
        <c:axId val="423051536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Georgia" panose="02040502050405020303" pitchFamily="18" charset="0"/>
                <a:ea typeface="+mn-ea"/>
                <a:cs typeface="+mn-cs"/>
              </a:defRPr>
            </a:pPr>
            <a:endParaRPr lang="ko-KR"/>
          </a:p>
        </c:txPr>
        <c:crossAx val="423051144"/>
        <c:crosses val="autoZero"/>
        <c:crossBetween val="between"/>
        <c:majorUnit val="10"/>
      </c:valAx>
      <c:spPr>
        <a:noFill/>
        <a:ln w="25400"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Georgia" panose="02040502050405020303" pitchFamily="18" charset="0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1400">
          <a:latin typeface="Georgia" panose="02040502050405020303" pitchFamily="18" charset="0"/>
        </a:defRPr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BC99D7-26EA-4E84-A3DC-2D9F5D2C28CB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BFC9C3-FA61-4324-B1DE-0D57611DA5E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8938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. Trends of the crude and age- and sex- standardized incidence rates of cancer-related ED visits per 100,000 population according to the cancer type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) Lung cancer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) Liver cancer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) Colorectal cancer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) Stomach cancer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) Pancreas cancer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BFC9C3-FA61-4324-B1DE-0D57611DA5EF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48686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3840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0195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4421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5947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2310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9383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1906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659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619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3745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6691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7F802-0B33-45A3-B9DF-7AE193C394D3}" type="datetimeFigureOut">
              <a:rPr lang="ko-KR" altLang="en-US" smtClean="0"/>
              <a:t>2021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F9C9D-30DE-4D8C-97F3-DE090ADF3A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2316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BE0D5CE-186B-4F01-847A-A0CEF1EC81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996224"/>
          </a:xfrm>
        </p:spPr>
        <p:txBody>
          <a:bodyPr/>
          <a:lstStyle/>
          <a:p>
            <a:r>
              <a:rPr lang="en-US" altLang="ko-KR" dirty="0">
                <a:latin typeface="Georgia" panose="02040502050405020303" pitchFamily="18" charset="0"/>
              </a:rPr>
              <a:t>Supplement </a:t>
            </a:r>
            <a:r>
              <a:rPr lang="en-US" altLang="ko-KR" dirty="0" smtClean="0">
                <a:latin typeface="Georgia" panose="02040502050405020303" pitchFamily="18" charset="0"/>
              </a:rPr>
              <a:t>Figure 1</a:t>
            </a:r>
            <a:endParaRPr lang="ko-KR" altLang="en-US" dirty="0">
              <a:latin typeface="Georgia" panose="02040502050405020303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31850" y="3012141"/>
            <a:ext cx="975615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Georgia" panose="02040502050405020303" pitchFamily="18" charset="0"/>
              </a:rPr>
              <a:t>Supplementary </a:t>
            </a:r>
            <a:r>
              <a:rPr lang="en-US" altLang="ko-KR" dirty="0" smtClean="0">
                <a:latin typeface="Georgia" panose="02040502050405020303" pitchFamily="18" charset="0"/>
              </a:rPr>
              <a:t>Figure 1. </a:t>
            </a:r>
            <a:r>
              <a:rPr lang="en-US" altLang="ko-KR" dirty="0">
                <a:latin typeface="Georgia" panose="02040502050405020303" pitchFamily="18" charset="0"/>
              </a:rPr>
              <a:t>Trends of the crude and age- and sex-standardized incidence rates of cancer-related ED visits per 100,000 population according to the cancer type</a:t>
            </a:r>
          </a:p>
          <a:p>
            <a:r>
              <a:rPr lang="en-US" altLang="ko-KR" dirty="0">
                <a:latin typeface="Georgia" panose="02040502050405020303" pitchFamily="18" charset="0"/>
              </a:rPr>
              <a:t>A) Lung cancer</a:t>
            </a:r>
          </a:p>
          <a:p>
            <a:r>
              <a:rPr lang="en-US" altLang="ko-KR" dirty="0">
                <a:latin typeface="Georgia" panose="02040502050405020303" pitchFamily="18" charset="0"/>
              </a:rPr>
              <a:t>B) Liver cancer</a:t>
            </a:r>
          </a:p>
          <a:p>
            <a:r>
              <a:rPr lang="en-US" altLang="ko-KR" dirty="0">
                <a:latin typeface="Georgia" panose="02040502050405020303" pitchFamily="18" charset="0"/>
              </a:rPr>
              <a:t>C) Colorectal cancer</a:t>
            </a:r>
          </a:p>
          <a:p>
            <a:r>
              <a:rPr lang="en-US" altLang="ko-KR" dirty="0">
                <a:latin typeface="Georgia" panose="02040502050405020303" pitchFamily="18" charset="0"/>
              </a:rPr>
              <a:t>D) Stomach cancer</a:t>
            </a:r>
          </a:p>
          <a:p>
            <a:r>
              <a:rPr lang="en-US" altLang="ko-KR" dirty="0">
                <a:latin typeface="Georgia" panose="02040502050405020303" pitchFamily="18" charset="0"/>
              </a:rPr>
              <a:t>E) Pancreas cancer</a:t>
            </a:r>
          </a:p>
          <a:p>
            <a:endParaRPr lang="ko-KR" altLang="en-US" dirty="0">
              <a:latin typeface="Georgia" panose="020405020504050203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68627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258BEC3-096D-4159-A377-4BEFA416BD08}"/>
              </a:ext>
            </a:extLst>
          </p:cNvPr>
          <p:cNvSpPr txBox="1"/>
          <p:nvPr/>
        </p:nvSpPr>
        <p:spPr>
          <a:xfrm>
            <a:off x="355599" y="721375"/>
            <a:ext cx="21964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A) Crude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2C0C70E-BCB4-4938-977A-8AFC965F53E4}"/>
              </a:ext>
            </a:extLst>
          </p:cNvPr>
          <p:cNvSpPr txBox="1"/>
          <p:nvPr/>
        </p:nvSpPr>
        <p:spPr>
          <a:xfrm>
            <a:off x="6368434" y="721375"/>
            <a:ext cx="3810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B) Age- and sex-standardized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2E839F-E783-44C1-856A-425B3D7E3342}"/>
              </a:ext>
            </a:extLst>
          </p:cNvPr>
          <p:cNvSpPr txBox="1"/>
          <p:nvPr/>
        </p:nvSpPr>
        <p:spPr>
          <a:xfrm>
            <a:off x="355599" y="315928"/>
            <a:ext cx="1386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A) Lung cancer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graphicFrame>
        <p:nvGraphicFramePr>
          <p:cNvPr id="13" name="차트 12">
            <a:extLst>
              <a:ext uri="{FF2B5EF4-FFF2-40B4-BE49-F238E27FC236}">
                <a16:creationId xmlns:a16="http://schemas.microsoft.com/office/drawing/2014/main" id="{01C5F93A-0C23-4E41-A097-8110603840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1005911"/>
              </p:ext>
            </p:extLst>
          </p:nvPr>
        </p:nvGraphicFramePr>
        <p:xfrm>
          <a:off x="355598" y="1403622"/>
          <a:ext cx="5648869" cy="5138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차트 13">
            <a:extLst>
              <a:ext uri="{FF2B5EF4-FFF2-40B4-BE49-F238E27FC236}">
                <a16:creationId xmlns:a16="http://schemas.microsoft.com/office/drawing/2014/main" id="{38F10562-4682-41C7-8CF7-E6B07F7DA1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1310762"/>
              </p:ext>
            </p:extLst>
          </p:nvPr>
        </p:nvGraphicFramePr>
        <p:xfrm>
          <a:off x="6359301" y="1403622"/>
          <a:ext cx="5648868" cy="5138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024403D3-A322-4999-96E1-E5308B66F529}"/>
              </a:ext>
            </a:extLst>
          </p:cNvPr>
          <p:cNvSpPr txBox="1"/>
          <p:nvPr/>
        </p:nvSpPr>
        <p:spPr>
          <a:xfrm>
            <a:off x="9355503" y="1095845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826A855-CD3B-496C-A04B-938EE0622378}"/>
              </a:ext>
            </a:extLst>
          </p:cNvPr>
          <p:cNvSpPr txBox="1"/>
          <p:nvPr/>
        </p:nvSpPr>
        <p:spPr>
          <a:xfrm>
            <a:off x="3263646" y="1093134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4664E0F-6262-4652-952C-C8FADA7A759F}"/>
              </a:ext>
            </a:extLst>
          </p:cNvPr>
          <p:cNvSpPr txBox="1"/>
          <p:nvPr/>
        </p:nvSpPr>
        <p:spPr>
          <a:xfrm>
            <a:off x="3792169" y="4271036"/>
            <a:ext cx="2052000" cy="68400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</a:t>
            </a:r>
            <a:r>
              <a:rPr lang="en-US" altLang="ko-KR" sz="1200" dirty="0" smtClean="0">
                <a:latin typeface="Georgia" panose="02040502050405020303" pitchFamily="18" charset="0"/>
              </a:rPr>
              <a:t>visits, 0.19</a:t>
            </a:r>
            <a:endParaRPr lang="en-US" altLang="ko-KR" sz="12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 smtClean="0">
                <a:latin typeface="Georgia" panose="02040502050405020303" pitchFamily="18" charset="0"/>
              </a:rPr>
              <a:t>Hospital admission, 0.85</a:t>
            </a:r>
            <a:endParaRPr lang="en-US" altLang="ko-KR" sz="1200" dirty="0">
              <a:latin typeface="Georgia" panose="02040502050405020303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FEDD439-12C8-41EE-A1B9-52E11E393539}"/>
              </a:ext>
            </a:extLst>
          </p:cNvPr>
          <p:cNvSpPr txBox="1"/>
          <p:nvPr/>
        </p:nvSpPr>
        <p:spPr>
          <a:xfrm>
            <a:off x="9817561" y="4271036"/>
            <a:ext cx="2052000" cy="68400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visits, </a:t>
            </a:r>
            <a:r>
              <a:rPr lang="en-US" altLang="ko-KR" sz="1200" dirty="0" smtClean="0">
                <a:latin typeface="Georgia" panose="02040502050405020303" pitchFamily="18" charset="0"/>
              </a:rPr>
              <a:t>0.74</a:t>
            </a:r>
            <a:endParaRPr lang="en-US" altLang="ko-KR" sz="12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Hospital admission, 1.00</a:t>
            </a:r>
          </a:p>
        </p:txBody>
      </p:sp>
    </p:spTree>
    <p:extLst>
      <p:ext uri="{BB962C8B-B14F-4D97-AF65-F5344CB8AC3E}">
        <p14:creationId xmlns:p14="http://schemas.microsoft.com/office/powerpoint/2010/main" val="24941664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52B5D9A-7BEB-4C2A-BF1F-AD7A22E8C0E0}"/>
              </a:ext>
            </a:extLst>
          </p:cNvPr>
          <p:cNvSpPr txBox="1"/>
          <p:nvPr/>
        </p:nvSpPr>
        <p:spPr>
          <a:xfrm>
            <a:off x="355599" y="721375"/>
            <a:ext cx="21964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A) Crude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93C44A4-1644-4E2C-BD41-F03B85C29996}"/>
              </a:ext>
            </a:extLst>
          </p:cNvPr>
          <p:cNvSpPr txBox="1"/>
          <p:nvPr/>
        </p:nvSpPr>
        <p:spPr>
          <a:xfrm>
            <a:off x="6368434" y="721375"/>
            <a:ext cx="3810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B) Age- and sex-standardized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206BE00-938E-45CC-8111-5CB8FB3F5C72}"/>
              </a:ext>
            </a:extLst>
          </p:cNvPr>
          <p:cNvSpPr txBox="1"/>
          <p:nvPr/>
        </p:nvSpPr>
        <p:spPr>
          <a:xfrm>
            <a:off x="355599" y="315928"/>
            <a:ext cx="1386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B) Liver cancer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graphicFrame>
        <p:nvGraphicFramePr>
          <p:cNvPr id="13" name="차트 12">
            <a:extLst>
              <a:ext uri="{FF2B5EF4-FFF2-40B4-BE49-F238E27FC236}">
                <a16:creationId xmlns:a16="http://schemas.microsoft.com/office/drawing/2014/main" id="{DC12F60D-BC1A-4CCA-BF5C-2CEDEC844C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3727081"/>
              </p:ext>
            </p:extLst>
          </p:nvPr>
        </p:nvGraphicFramePr>
        <p:xfrm>
          <a:off x="355599" y="1399566"/>
          <a:ext cx="5740401" cy="51425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차트 13">
            <a:extLst>
              <a:ext uri="{FF2B5EF4-FFF2-40B4-BE49-F238E27FC236}">
                <a16:creationId xmlns:a16="http://schemas.microsoft.com/office/drawing/2014/main" id="{FF28735C-920C-4E86-BBEA-CECA3E34D0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3156795"/>
              </p:ext>
            </p:extLst>
          </p:nvPr>
        </p:nvGraphicFramePr>
        <p:xfrm>
          <a:off x="6368433" y="1399566"/>
          <a:ext cx="5740401" cy="51425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2F335641-95D8-496C-8544-A1B569220EDD}"/>
              </a:ext>
            </a:extLst>
          </p:cNvPr>
          <p:cNvSpPr txBox="1"/>
          <p:nvPr/>
        </p:nvSpPr>
        <p:spPr>
          <a:xfrm>
            <a:off x="9183735" y="1091789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DED0E11-6A85-4ED1-B1DC-6C4A203B9293}"/>
              </a:ext>
            </a:extLst>
          </p:cNvPr>
          <p:cNvSpPr txBox="1"/>
          <p:nvPr/>
        </p:nvSpPr>
        <p:spPr>
          <a:xfrm>
            <a:off x="3351801" y="1091788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4664E0F-6262-4652-952C-C8FADA7A759F}"/>
              </a:ext>
            </a:extLst>
          </p:cNvPr>
          <p:cNvSpPr txBox="1"/>
          <p:nvPr/>
        </p:nvSpPr>
        <p:spPr>
          <a:xfrm>
            <a:off x="3877894" y="4261901"/>
            <a:ext cx="2052000" cy="68400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</a:t>
            </a:r>
            <a:r>
              <a:rPr lang="en-US" altLang="ko-KR" sz="1200" dirty="0" smtClean="0">
                <a:latin typeface="Georgia" panose="02040502050405020303" pitchFamily="18" charset="0"/>
              </a:rPr>
              <a:t>visits, 0.76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 smtClean="0">
                <a:latin typeface="Georgia" panose="02040502050405020303" pitchFamily="18" charset="0"/>
              </a:rPr>
              <a:t>Hospital admission, 0.99</a:t>
            </a:r>
            <a:endParaRPr lang="en-US" altLang="ko-KR" sz="1200" dirty="0">
              <a:latin typeface="Georgia" panose="02040502050405020303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FEDD439-12C8-41EE-A1B9-52E11E393539}"/>
              </a:ext>
            </a:extLst>
          </p:cNvPr>
          <p:cNvSpPr txBox="1"/>
          <p:nvPr/>
        </p:nvSpPr>
        <p:spPr>
          <a:xfrm>
            <a:off x="9903286" y="4265347"/>
            <a:ext cx="2052000" cy="677108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visits, 0.99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 smtClean="0">
                <a:latin typeface="Georgia" panose="02040502050405020303" pitchFamily="18" charset="0"/>
              </a:rPr>
              <a:t>Hospital </a:t>
            </a:r>
            <a:r>
              <a:rPr lang="en-US" altLang="ko-KR" sz="1200" dirty="0">
                <a:latin typeface="Georgia" panose="02040502050405020303" pitchFamily="18" charset="0"/>
              </a:rPr>
              <a:t>admission, </a:t>
            </a:r>
            <a:r>
              <a:rPr lang="en-US" altLang="ko-KR" sz="1200" dirty="0" smtClean="0">
                <a:latin typeface="Georgia" panose="02040502050405020303" pitchFamily="18" charset="0"/>
              </a:rPr>
              <a:t>1.00</a:t>
            </a:r>
            <a:endParaRPr lang="en-US" altLang="ko-KR" sz="1200" dirty="0">
              <a:latin typeface="Georgia" panose="020405020504050203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17673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29F9B78-AE72-4FA9-B534-6BC7C89FEEAE}"/>
              </a:ext>
            </a:extLst>
          </p:cNvPr>
          <p:cNvSpPr txBox="1"/>
          <p:nvPr/>
        </p:nvSpPr>
        <p:spPr>
          <a:xfrm>
            <a:off x="355599" y="721375"/>
            <a:ext cx="21964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A) Crude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2D74F4E-8545-4B71-86E6-2A3E4F47E38C}"/>
              </a:ext>
            </a:extLst>
          </p:cNvPr>
          <p:cNvSpPr txBox="1"/>
          <p:nvPr/>
        </p:nvSpPr>
        <p:spPr>
          <a:xfrm>
            <a:off x="6368434" y="721375"/>
            <a:ext cx="3810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B) Age- and sex-standardized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D775711-48F7-433D-969B-07D64223008F}"/>
              </a:ext>
            </a:extLst>
          </p:cNvPr>
          <p:cNvSpPr txBox="1"/>
          <p:nvPr/>
        </p:nvSpPr>
        <p:spPr>
          <a:xfrm>
            <a:off x="355599" y="315928"/>
            <a:ext cx="17780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C) Colorectal cancer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graphicFrame>
        <p:nvGraphicFramePr>
          <p:cNvPr id="13" name="차트 12">
            <a:extLst>
              <a:ext uri="{FF2B5EF4-FFF2-40B4-BE49-F238E27FC236}">
                <a16:creationId xmlns:a16="http://schemas.microsoft.com/office/drawing/2014/main" id="{2FDE0657-B4C0-4A52-A433-4BA987284A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1227682"/>
              </p:ext>
            </p:extLst>
          </p:nvPr>
        </p:nvGraphicFramePr>
        <p:xfrm>
          <a:off x="355598" y="1399566"/>
          <a:ext cx="5740401" cy="51425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차트 13">
            <a:extLst>
              <a:ext uri="{FF2B5EF4-FFF2-40B4-BE49-F238E27FC236}">
                <a16:creationId xmlns:a16="http://schemas.microsoft.com/office/drawing/2014/main" id="{F8B9C52F-16B2-4024-8F29-177E7D455C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1961726"/>
              </p:ext>
            </p:extLst>
          </p:nvPr>
        </p:nvGraphicFramePr>
        <p:xfrm>
          <a:off x="6368433" y="1399566"/>
          <a:ext cx="5740401" cy="51425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2F335641-95D8-496C-8544-A1B569220EDD}"/>
              </a:ext>
            </a:extLst>
          </p:cNvPr>
          <p:cNvSpPr txBox="1"/>
          <p:nvPr/>
        </p:nvSpPr>
        <p:spPr>
          <a:xfrm>
            <a:off x="9183735" y="1091789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DED0E11-6A85-4ED1-B1DC-6C4A203B9293}"/>
              </a:ext>
            </a:extLst>
          </p:cNvPr>
          <p:cNvSpPr txBox="1"/>
          <p:nvPr/>
        </p:nvSpPr>
        <p:spPr>
          <a:xfrm>
            <a:off x="3351801" y="1091788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4664E0F-6262-4652-952C-C8FADA7A759F}"/>
              </a:ext>
            </a:extLst>
          </p:cNvPr>
          <p:cNvSpPr txBox="1"/>
          <p:nvPr/>
        </p:nvSpPr>
        <p:spPr>
          <a:xfrm>
            <a:off x="3877894" y="1626922"/>
            <a:ext cx="2052000" cy="68400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</a:t>
            </a:r>
            <a:r>
              <a:rPr lang="en-US" altLang="ko-KR" sz="1200" dirty="0" smtClean="0">
                <a:latin typeface="Georgia" panose="02040502050405020303" pitchFamily="18" charset="0"/>
              </a:rPr>
              <a:t>visits, 0.50</a:t>
            </a:r>
            <a:endParaRPr lang="en-US" altLang="ko-KR" sz="12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 smtClean="0">
                <a:latin typeface="Georgia" panose="02040502050405020303" pitchFamily="18" charset="0"/>
              </a:rPr>
              <a:t>Hospital admission, 0.87</a:t>
            </a:r>
            <a:endParaRPr lang="en-US" altLang="ko-KR" sz="1200" dirty="0">
              <a:latin typeface="Georgia" panose="02040502050405020303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FEDD439-12C8-41EE-A1B9-52E11E393539}"/>
              </a:ext>
            </a:extLst>
          </p:cNvPr>
          <p:cNvSpPr txBox="1"/>
          <p:nvPr/>
        </p:nvSpPr>
        <p:spPr>
          <a:xfrm>
            <a:off x="9922336" y="1626922"/>
            <a:ext cx="2052000" cy="68400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visits, </a:t>
            </a:r>
            <a:r>
              <a:rPr lang="en-US" altLang="ko-KR" sz="1200" dirty="0" smtClean="0">
                <a:latin typeface="Georgia" panose="02040502050405020303" pitchFamily="18" charset="0"/>
              </a:rPr>
              <a:t>0.89</a:t>
            </a:r>
            <a:endParaRPr lang="en-US" altLang="ko-KR" sz="12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Hospital admission, 1.00</a:t>
            </a:r>
          </a:p>
        </p:txBody>
      </p:sp>
    </p:spTree>
    <p:extLst>
      <p:ext uri="{BB962C8B-B14F-4D97-AF65-F5344CB8AC3E}">
        <p14:creationId xmlns:p14="http://schemas.microsoft.com/office/powerpoint/2010/main" val="17705557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A50F11A-89E4-46D5-9DAD-19CBB5F42823}"/>
              </a:ext>
            </a:extLst>
          </p:cNvPr>
          <p:cNvSpPr txBox="1"/>
          <p:nvPr/>
        </p:nvSpPr>
        <p:spPr>
          <a:xfrm>
            <a:off x="355599" y="721375"/>
            <a:ext cx="21964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A) Crude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FED96E-3ED9-40B4-924A-487610437B48}"/>
              </a:ext>
            </a:extLst>
          </p:cNvPr>
          <p:cNvSpPr txBox="1"/>
          <p:nvPr/>
        </p:nvSpPr>
        <p:spPr>
          <a:xfrm>
            <a:off x="6368434" y="721375"/>
            <a:ext cx="3810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B) Age- and sex-standardized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0B3F02F-2967-4FB8-BF80-03DDAB621382}"/>
              </a:ext>
            </a:extLst>
          </p:cNvPr>
          <p:cNvSpPr txBox="1"/>
          <p:nvPr/>
        </p:nvSpPr>
        <p:spPr>
          <a:xfrm>
            <a:off x="355599" y="315928"/>
            <a:ext cx="1737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D) Stomach cancer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graphicFrame>
        <p:nvGraphicFramePr>
          <p:cNvPr id="13" name="차트 12">
            <a:extLst>
              <a:ext uri="{FF2B5EF4-FFF2-40B4-BE49-F238E27FC236}">
                <a16:creationId xmlns:a16="http://schemas.microsoft.com/office/drawing/2014/main" id="{796AABB8-3642-4296-B037-D4A0429512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277880"/>
              </p:ext>
            </p:extLst>
          </p:nvPr>
        </p:nvGraphicFramePr>
        <p:xfrm>
          <a:off x="355599" y="1407070"/>
          <a:ext cx="5648869" cy="5135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차트 13">
            <a:extLst>
              <a:ext uri="{FF2B5EF4-FFF2-40B4-BE49-F238E27FC236}">
                <a16:creationId xmlns:a16="http://schemas.microsoft.com/office/drawing/2014/main" id="{ABCA74F8-30A2-41EF-BF17-03D2057BC2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9499826"/>
              </p:ext>
            </p:extLst>
          </p:nvPr>
        </p:nvGraphicFramePr>
        <p:xfrm>
          <a:off x="6368434" y="1407070"/>
          <a:ext cx="5648869" cy="5135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14056A6B-4EB9-4CE5-AEA3-E270576EAFB2}"/>
              </a:ext>
            </a:extLst>
          </p:cNvPr>
          <p:cNvSpPr txBox="1"/>
          <p:nvPr/>
        </p:nvSpPr>
        <p:spPr>
          <a:xfrm>
            <a:off x="9139000" y="1066086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E2F9428-3862-4DFF-9145-4A55158EEA6C}"/>
              </a:ext>
            </a:extLst>
          </p:cNvPr>
          <p:cNvSpPr txBox="1"/>
          <p:nvPr/>
        </p:nvSpPr>
        <p:spPr>
          <a:xfrm>
            <a:off x="3307066" y="1066085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4664E0F-6262-4652-952C-C8FADA7A759F}"/>
              </a:ext>
            </a:extLst>
          </p:cNvPr>
          <p:cNvSpPr txBox="1"/>
          <p:nvPr/>
        </p:nvSpPr>
        <p:spPr>
          <a:xfrm>
            <a:off x="3792169" y="4271036"/>
            <a:ext cx="2052000" cy="68400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</a:t>
            </a:r>
            <a:r>
              <a:rPr lang="en-US" altLang="ko-KR" sz="1200" dirty="0" smtClean="0">
                <a:latin typeface="Georgia" panose="02040502050405020303" pitchFamily="18" charset="0"/>
              </a:rPr>
              <a:t>visits, 0.97</a:t>
            </a:r>
            <a:endParaRPr lang="en-US" altLang="ko-KR" sz="12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 smtClean="0">
                <a:latin typeface="Georgia" panose="02040502050405020303" pitchFamily="18" charset="0"/>
              </a:rPr>
              <a:t>Hospital admission</a:t>
            </a:r>
            <a:r>
              <a:rPr lang="en-US" altLang="ko-KR" sz="1200" dirty="0">
                <a:latin typeface="Georgia" panose="02040502050405020303" pitchFamily="18" charset="0"/>
              </a:rPr>
              <a:t>, 1.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FEDD439-12C8-41EE-A1B9-52E11E393539}"/>
              </a:ext>
            </a:extLst>
          </p:cNvPr>
          <p:cNvSpPr txBox="1"/>
          <p:nvPr/>
        </p:nvSpPr>
        <p:spPr>
          <a:xfrm>
            <a:off x="9817561" y="4271036"/>
            <a:ext cx="2052000" cy="68400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visits, 1.00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 smtClean="0">
                <a:latin typeface="Georgia" panose="02040502050405020303" pitchFamily="18" charset="0"/>
              </a:rPr>
              <a:t>Hospital </a:t>
            </a:r>
            <a:r>
              <a:rPr lang="en-US" altLang="ko-KR" sz="1200" dirty="0">
                <a:latin typeface="Georgia" panose="02040502050405020303" pitchFamily="18" charset="0"/>
              </a:rPr>
              <a:t>admission, 1.00</a:t>
            </a:r>
          </a:p>
        </p:txBody>
      </p:sp>
    </p:spTree>
    <p:extLst>
      <p:ext uri="{BB962C8B-B14F-4D97-AF65-F5344CB8AC3E}">
        <p14:creationId xmlns:p14="http://schemas.microsoft.com/office/powerpoint/2010/main" val="35091199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CBDD246-36DA-4B60-A958-FFAE9DEB4479}"/>
              </a:ext>
            </a:extLst>
          </p:cNvPr>
          <p:cNvSpPr txBox="1"/>
          <p:nvPr/>
        </p:nvSpPr>
        <p:spPr>
          <a:xfrm>
            <a:off x="355599" y="721375"/>
            <a:ext cx="21964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A) Crude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3D3C1C4-F26E-440A-B7F9-0478BA1AA812}"/>
              </a:ext>
            </a:extLst>
          </p:cNvPr>
          <p:cNvSpPr txBox="1"/>
          <p:nvPr/>
        </p:nvSpPr>
        <p:spPr>
          <a:xfrm>
            <a:off x="6368434" y="721375"/>
            <a:ext cx="3810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(B) Age- and sex-standardized incidence rates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EB93F7F-EA24-4C46-BB01-0D058E7816F6}"/>
              </a:ext>
            </a:extLst>
          </p:cNvPr>
          <p:cNvSpPr txBox="1"/>
          <p:nvPr/>
        </p:nvSpPr>
        <p:spPr>
          <a:xfrm>
            <a:off x="355599" y="315928"/>
            <a:ext cx="1688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E) Pancreas cancer</a:t>
            </a:r>
            <a:endParaRPr lang="ko-KR" altLang="en-US" sz="1400" dirty="0">
              <a:latin typeface="Georgia" panose="02040502050405020303" pitchFamily="18" charset="0"/>
            </a:endParaRPr>
          </a:p>
        </p:txBody>
      </p:sp>
      <p:graphicFrame>
        <p:nvGraphicFramePr>
          <p:cNvPr id="13" name="차트 12">
            <a:extLst>
              <a:ext uri="{FF2B5EF4-FFF2-40B4-BE49-F238E27FC236}">
                <a16:creationId xmlns:a16="http://schemas.microsoft.com/office/drawing/2014/main" id="{FE45F6FF-9B6D-4407-B664-4A2547F9F37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8982963"/>
              </p:ext>
            </p:extLst>
          </p:nvPr>
        </p:nvGraphicFramePr>
        <p:xfrm>
          <a:off x="354013" y="1385695"/>
          <a:ext cx="5741987" cy="51563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차트 13">
            <a:extLst>
              <a:ext uri="{FF2B5EF4-FFF2-40B4-BE49-F238E27FC236}">
                <a16:creationId xmlns:a16="http://schemas.microsoft.com/office/drawing/2014/main" id="{33DA60E6-2BCD-4E12-A6CF-D0F1E11890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9402637"/>
              </p:ext>
            </p:extLst>
          </p:nvPr>
        </p:nvGraphicFramePr>
        <p:xfrm>
          <a:off x="6324206" y="1385694"/>
          <a:ext cx="5741987" cy="51563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81768B31-B320-44CD-BBCE-C7585D82C2E8}"/>
              </a:ext>
            </a:extLst>
          </p:cNvPr>
          <p:cNvSpPr txBox="1"/>
          <p:nvPr/>
        </p:nvSpPr>
        <p:spPr>
          <a:xfrm>
            <a:off x="9183735" y="1091789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2C6F5E5-B089-47EE-BE37-2F6D4F0472A5}"/>
              </a:ext>
            </a:extLst>
          </p:cNvPr>
          <p:cNvSpPr txBox="1"/>
          <p:nvPr/>
        </p:nvSpPr>
        <p:spPr>
          <a:xfrm>
            <a:off x="3351801" y="1091788"/>
            <a:ext cx="265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/>
            <a:r>
              <a:rPr lang="en-US" altLang="ko-KR" sz="1400" dirty="0">
                <a:latin typeface="Georgia" panose="02040502050405020303" pitchFamily="18" charset="0"/>
              </a:rPr>
              <a:t>(per 100,000 population)</a:t>
            </a:r>
            <a:endParaRPr lang="ko-KR" alt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4664E0F-6262-4652-952C-C8FADA7A759F}"/>
              </a:ext>
            </a:extLst>
          </p:cNvPr>
          <p:cNvSpPr txBox="1"/>
          <p:nvPr/>
        </p:nvSpPr>
        <p:spPr>
          <a:xfrm>
            <a:off x="3877894" y="1632611"/>
            <a:ext cx="2052000" cy="68400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</a:t>
            </a:r>
            <a:r>
              <a:rPr lang="en-US" altLang="ko-KR" sz="1200" dirty="0" smtClean="0">
                <a:latin typeface="Georgia" panose="02040502050405020303" pitchFamily="18" charset="0"/>
              </a:rPr>
              <a:t>visits, 0.26</a:t>
            </a:r>
            <a:endParaRPr lang="en-US" altLang="ko-KR" sz="12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 smtClean="0">
                <a:latin typeface="Georgia" panose="02040502050405020303" pitchFamily="18" charset="0"/>
              </a:rPr>
              <a:t>Hospital admission, 0.67</a:t>
            </a:r>
            <a:endParaRPr lang="en-US" altLang="ko-KR" sz="1200" dirty="0">
              <a:latin typeface="Georgia" panose="02040502050405020303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FEDD439-12C8-41EE-A1B9-52E11E393539}"/>
              </a:ext>
            </a:extLst>
          </p:cNvPr>
          <p:cNvSpPr txBox="1"/>
          <p:nvPr/>
        </p:nvSpPr>
        <p:spPr>
          <a:xfrm>
            <a:off x="9884236" y="1632611"/>
            <a:ext cx="2052000" cy="68400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Georgia" panose="02040502050405020303" pitchFamily="18" charset="0"/>
              </a:rPr>
              <a:t>Yearly </a:t>
            </a:r>
            <a:r>
              <a:rPr lang="en-US" altLang="ko-KR" sz="1400" dirty="0" smtClean="0">
                <a:latin typeface="Georgia" panose="02040502050405020303" pitchFamily="18" charset="0"/>
              </a:rPr>
              <a:t>trends</a:t>
            </a:r>
            <a:endParaRPr lang="en-US" altLang="ko-KR" sz="14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ED visits, </a:t>
            </a:r>
            <a:r>
              <a:rPr lang="en-US" altLang="ko-KR" sz="1200" dirty="0" smtClean="0">
                <a:latin typeface="Georgia" panose="02040502050405020303" pitchFamily="18" charset="0"/>
              </a:rPr>
              <a:t>0.51</a:t>
            </a:r>
            <a:endParaRPr lang="en-US" altLang="ko-KR" sz="1200" dirty="0">
              <a:latin typeface="Georgia" panose="02040502050405020303" pitchFamily="18" charset="0"/>
            </a:endParaRPr>
          </a:p>
          <a:p>
            <a:pPr marL="171450" indent="-171450">
              <a:buFontTx/>
              <a:buChar char="-"/>
            </a:pPr>
            <a:r>
              <a:rPr lang="en-US" altLang="ko-KR" sz="1200" dirty="0">
                <a:latin typeface="Georgia" panose="02040502050405020303" pitchFamily="18" charset="0"/>
              </a:rPr>
              <a:t>Hospital admission, </a:t>
            </a:r>
            <a:r>
              <a:rPr lang="en-US" altLang="ko-KR" sz="1200" dirty="0" smtClean="0">
                <a:latin typeface="Georgia" panose="02040502050405020303" pitchFamily="18" charset="0"/>
              </a:rPr>
              <a:t>0.93</a:t>
            </a:r>
            <a:endParaRPr lang="en-US" altLang="ko-KR" sz="1200" dirty="0">
              <a:latin typeface="Georgia" panose="020405020504050203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8432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336</Words>
  <Application>Microsoft Office PowerPoint</Application>
  <PresentationFormat>와이드스크린</PresentationFormat>
  <Paragraphs>69</Paragraphs>
  <Slides>6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0" baseType="lpstr">
      <vt:lpstr>맑은 고딕</vt:lpstr>
      <vt:lpstr>Arial</vt:lpstr>
      <vt:lpstr>Georgia</vt:lpstr>
      <vt:lpstr>Office 테마</vt:lpstr>
      <vt:lpstr>Supplement Figure 1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NUH</dc:creator>
  <cp:lastModifiedBy>Young Sun Ro</cp:lastModifiedBy>
  <cp:revision>12</cp:revision>
  <dcterms:created xsi:type="dcterms:W3CDTF">2021-05-03T08:56:51Z</dcterms:created>
  <dcterms:modified xsi:type="dcterms:W3CDTF">2021-10-25T09:11:13Z</dcterms:modified>
</cp:coreProperties>
</file>